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AD338-E23F-306B-DF5B-9E7B090EBF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986F739-E864-AAB4-64FB-83AA7C2719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3640D4-F33C-BF19-336D-70F0012DB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4F3F5-4A0C-4851-99CC-FF25D57B23FA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9FF13B-0738-33CF-EA87-40BB4B6B78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FD7789-3D16-0D90-6ADC-56DEA66A2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E64BF-A1E8-431C-A6B3-C2FA9A8DC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59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818E96-4F94-A8F4-9596-9BD65EC9ED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BC3FD31-79D8-ACC2-67D0-DA00C1220E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30B46A-2A60-BA39-343F-17CE61FA9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4F3F5-4A0C-4851-99CC-FF25D57B23FA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612BB-68D1-BAD6-457D-3BF9845A31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36D018-7EB3-8212-689E-0FE25969A8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E64BF-A1E8-431C-A6B3-C2FA9A8DC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672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A77882-FE83-5249-43EC-9FCF241E82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69D58F-60DC-0A25-BE55-C1DC76EE43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7861BF-FD54-E797-1C0B-F7BBD17E9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4F3F5-4A0C-4851-99CC-FF25D57B23FA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5E41CE-F08B-93F7-F920-67246754F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934D92-B607-3B74-F404-921D2FEC9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E64BF-A1E8-431C-A6B3-C2FA9A8DC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609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887640-4E6F-9B42-8C3D-CB39B3252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CA4B2D-6B26-88E1-4B9C-50BC3D5CFD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7CE430-0F17-FCF1-FD99-313F51988A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4F3F5-4A0C-4851-99CC-FF25D57B23FA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8A3D91-6874-B07B-8A91-E618383E19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BBD07C-9526-F191-8604-853F60E53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E64BF-A1E8-431C-A6B3-C2FA9A8DC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063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5F755B-7D00-831A-8204-31273BC6D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404285-96B1-7DA0-73FF-ABD94E0ED8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DBAA65-788E-3CD2-7387-E780908B5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4F3F5-4A0C-4851-99CC-FF25D57B23FA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BFD7B7-42D5-54AD-D67F-BF1C4E8DA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DA41B0-27E1-166E-EE4A-719460932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E64BF-A1E8-431C-A6B3-C2FA9A8DC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365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F2226C-B6BD-ED63-E70B-790BA132A4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C62457-7E2A-A0EB-069D-41EB0501E1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822682-2C58-AA10-D63D-F8DD480E53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77B7BE-CF9E-EA1F-DD4D-C8D88AD79F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4F3F5-4A0C-4851-99CC-FF25D57B23FA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692C46-47EC-CA45-1A3F-DF113D2C8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3CC36C-BADB-29BD-FE28-C39EF4BC47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E64BF-A1E8-431C-A6B3-C2FA9A8DC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226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5C906E-75CF-D8CF-6FC5-C2B38DD5DC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A44654-0F14-24B7-3C2D-F41491BEDF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FBE424-7856-DB1A-9160-1BCDB5FA71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38F6111-D929-0697-F1A5-05E832153D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6BEF1F-164F-49B3-F1EF-FDA4594FA6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16864AC-ADFC-81AB-F07C-321888C82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4F3F5-4A0C-4851-99CC-FF25D57B23FA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60DC534-CFBF-1D56-3F2E-D49F40BEB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CD0821-030A-620E-5D8D-CF29A1295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E64BF-A1E8-431C-A6B3-C2FA9A8DC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967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E66383-B679-AB39-653C-893B9909A3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CD0F4C9-C7CF-49E1-8B17-3DA7ABFC2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4F3F5-4A0C-4851-99CC-FF25D57B23FA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28F0F2-8495-FC53-7EA2-F31E7CC9A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E1024EB-4EB9-83F1-9EF8-F3D0BEF04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E64BF-A1E8-431C-A6B3-C2FA9A8DC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402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5FFF974-124C-02BA-A2E6-C4DB3D430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4F3F5-4A0C-4851-99CC-FF25D57B23FA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1172AC-82F9-0BC0-34A5-9931D06BE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F3F84E3-B8F3-471C-A60A-176E5B78C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E64BF-A1E8-431C-A6B3-C2FA9A8DC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850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572F0D-3981-565B-09D9-5FD528AC99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9ACA71-1B31-3B4F-4419-B4197ACD18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EFE8A5-1868-CF44-3BBA-5002CE278E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274C29-B043-6ABA-4300-3687EAFB1B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4F3F5-4A0C-4851-99CC-FF25D57B23FA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426BE7-FD28-2153-3D00-1D20E9B00A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BA6FAF-AE0C-D09B-C07F-08C63F533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E64BF-A1E8-431C-A6B3-C2FA9A8DC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438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C06831-27B1-A876-D411-46D06C0CCD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6ADE81-FC24-5EC1-F40D-AC94707ECE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D87D20-2E24-7924-843C-E02098DFC1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76A022-18FC-C4DE-6704-1551D902E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4F3F5-4A0C-4851-99CC-FF25D57B23FA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1E3F81-8CE9-8B52-6235-EF3B071C7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6EAD95-D4C3-CF1A-1EA5-8B7BCB829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E64BF-A1E8-431C-A6B3-C2FA9A8DC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850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AF69E1-BFC3-F107-B6CE-C8D3BB9AD7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163913-BAAA-735B-7795-F41AF12342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3BE8FE-897A-625C-473D-FC8216F99D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14F3F5-4A0C-4851-99CC-FF25D57B23FA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CCA6E2-5E8C-D939-86FD-FF78B85AC4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5D7573-9A54-1FBD-193E-A8321C6330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AE64BF-A1E8-431C-A6B3-C2FA9A8DC2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223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jpg"/><Relationship Id="rId2" Type="http://schemas.openxmlformats.org/officeDocument/2006/relationships/image" Target="../media/image40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2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jpg"/><Relationship Id="rId2" Type="http://schemas.openxmlformats.org/officeDocument/2006/relationships/image" Target="../media/image43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6.jpg"/><Relationship Id="rId4" Type="http://schemas.openxmlformats.org/officeDocument/2006/relationships/image" Target="../media/image45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jpg"/><Relationship Id="rId2" Type="http://schemas.openxmlformats.org/officeDocument/2006/relationships/image" Target="../media/image4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jpg"/><Relationship Id="rId5" Type="http://schemas.openxmlformats.org/officeDocument/2006/relationships/image" Target="../media/image50.jpg"/><Relationship Id="rId4" Type="http://schemas.openxmlformats.org/officeDocument/2006/relationships/image" Target="../media/image49.jp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8.jpg"/><Relationship Id="rId3" Type="http://schemas.openxmlformats.org/officeDocument/2006/relationships/image" Target="../media/image53.jpg"/><Relationship Id="rId7" Type="http://schemas.openxmlformats.org/officeDocument/2006/relationships/image" Target="../media/image57.jpg"/><Relationship Id="rId2" Type="http://schemas.openxmlformats.org/officeDocument/2006/relationships/image" Target="../media/image52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6.jpg"/><Relationship Id="rId5" Type="http://schemas.openxmlformats.org/officeDocument/2006/relationships/image" Target="../media/image55.jpg"/><Relationship Id="rId4" Type="http://schemas.openxmlformats.org/officeDocument/2006/relationships/image" Target="../media/image54.jp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jpg"/><Relationship Id="rId2" Type="http://schemas.openxmlformats.org/officeDocument/2006/relationships/image" Target="../media/image59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3.jpg"/><Relationship Id="rId5" Type="http://schemas.openxmlformats.org/officeDocument/2006/relationships/image" Target="../media/image62.jpg"/><Relationship Id="rId4" Type="http://schemas.openxmlformats.org/officeDocument/2006/relationships/image" Target="../media/image61.jp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jpg"/><Relationship Id="rId2" Type="http://schemas.openxmlformats.org/officeDocument/2006/relationships/image" Target="../media/image64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7.jpg"/><Relationship Id="rId4" Type="http://schemas.openxmlformats.org/officeDocument/2006/relationships/image" Target="../media/image66.jp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jpg"/><Relationship Id="rId3" Type="http://schemas.openxmlformats.org/officeDocument/2006/relationships/image" Target="../media/image69.jpg"/><Relationship Id="rId7" Type="http://schemas.openxmlformats.org/officeDocument/2006/relationships/image" Target="../media/image73.jpg"/><Relationship Id="rId2" Type="http://schemas.openxmlformats.org/officeDocument/2006/relationships/image" Target="../media/image68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2.jpg"/><Relationship Id="rId5" Type="http://schemas.openxmlformats.org/officeDocument/2006/relationships/image" Target="../media/image71.jpg"/><Relationship Id="rId4" Type="http://schemas.openxmlformats.org/officeDocument/2006/relationships/image" Target="../media/image70.jp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6.jpg"/><Relationship Id="rId2" Type="http://schemas.openxmlformats.org/officeDocument/2006/relationships/image" Target="../media/image7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9.jpg"/><Relationship Id="rId5" Type="http://schemas.openxmlformats.org/officeDocument/2006/relationships/image" Target="../media/image78.jpg"/><Relationship Id="rId4" Type="http://schemas.openxmlformats.org/officeDocument/2006/relationships/image" Target="../media/image77.jp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6.jpg"/><Relationship Id="rId3" Type="http://schemas.openxmlformats.org/officeDocument/2006/relationships/image" Target="../media/image81.jpg"/><Relationship Id="rId7" Type="http://schemas.openxmlformats.org/officeDocument/2006/relationships/image" Target="../media/image85.jpg"/><Relationship Id="rId2" Type="http://schemas.openxmlformats.org/officeDocument/2006/relationships/image" Target="../media/image80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4.jpg"/><Relationship Id="rId5" Type="http://schemas.openxmlformats.org/officeDocument/2006/relationships/image" Target="../media/image83.jpg"/><Relationship Id="rId4" Type="http://schemas.openxmlformats.org/officeDocument/2006/relationships/image" Target="../media/image82.jpg"/><Relationship Id="rId9" Type="http://schemas.openxmlformats.org/officeDocument/2006/relationships/image" Target="../media/image87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g"/><Relationship Id="rId5" Type="http://schemas.openxmlformats.org/officeDocument/2006/relationships/image" Target="../media/image23.jpg"/><Relationship Id="rId4" Type="http://schemas.openxmlformats.org/officeDocument/2006/relationships/image" Target="../media/image22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g"/><Relationship Id="rId7" Type="http://schemas.openxmlformats.org/officeDocument/2006/relationships/image" Target="../media/image32.jpg"/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jpg"/><Relationship Id="rId5" Type="http://schemas.openxmlformats.org/officeDocument/2006/relationships/image" Target="../media/image30.jpg"/><Relationship Id="rId4" Type="http://schemas.openxmlformats.org/officeDocument/2006/relationships/image" Target="../media/image29.jp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jpg"/><Relationship Id="rId3" Type="http://schemas.openxmlformats.org/officeDocument/2006/relationships/image" Target="../media/image34.jpg"/><Relationship Id="rId7" Type="http://schemas.openxmlformats.org/officeDocument/2006/relationships/image" Target="../media/image38.jpg"/><Relationship Id="rId2" Type="http://schemas.openxmlformats.org/officeDocument/2006/relationships/image" Target="../media/image33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jpg"/><Relationship Id="rId5" Type="http://schemas.openxmlformats.org/officeDocument/2006/relationships/image" Target="../media/image36.jpg"/><Relationship Id="rId4" Type="http://schemas.openxmlformats.org/officeDocument/2006/relationships/image" Target="../media/image3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test results&#10;&#10;Description automatically generated">
            <a:extLst>
              <a:ext uri="{FF2B5EF4-FFF2-40B4-BE49-F238E27FC236}">
                <a16:creationId xmlns:a16="http://schemas.microsoft.com/office/drawing/2014/main" id="{E40279D1-0071-A2C2-1BE0-368CAF55F5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6585" y="1429402"/>
            <a:ext cx="3681530" cy="2620899"/>
          </a:xfrm>
          <a:prstGeom prst="rect">
            <a:avLst/>
          </a:prstGeom>
        </p:spPr>
      </p:pic>
      <p:pic>
        <p:nvPicPr>
          <p:cNvPr id="7" name="Picture 6" descr="A close-up of a test results&#10;&#10;Description automatically generated">
            <a:extLst>
              <a:ext uri="{FF2B5EF4-FFF2-40B4-BE49-F238E27FC236}">
                <a16:creationId xmlns:a16="http://schemas.microsoft.com/office/drawing/2014/main" id="{F1D5A34D-AE4C-805F-9E56-B79C9639B35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3707" y="1429402"/>
            <a:ext cx="3681533" cy="2620901"/>
          </a:xfrm>
          <a:prstGeom prst="rect">
            <a:avLst/>
          </a:prstGeom>
        </p:spPr>
      </p:pic>
      <p:pic>
        <p:nvPicPr>
          <p:cNvPr id="9" name="Picture 8" descr="A close-up of a test&#10;&#10;Description automatically generated">
            <a:extLst>
              <a:ext uri="{FF2B5EF4-FFF2-40B4-BE49-F238E27FC236}">
                <a16:creationId xmlns:a16="http://schemas.microsoft.com/office/drawing/2014/main" id="{AD84BCFE-795F-FB98-0A54-3261D9E1CF0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4001" y="4116896"/>
            <a:ext cx="3681531" cy="2620899"/>
          </a:xfrm>
          <a:prstGeom prst="rect">
            <a:avLst/>
          </a:prstGeom>
        </p:spPr>
      </p:pic>
      <p:pic>
        <p:nvPicPr>
          <p:cNvPr id="11" name="Picture 10" descr="A close-up of a whiteboard&#10;&#10;Description automatically generated">
            <a:extLst>
              <a:ext uri="{FF2B5EF4-FFF2-40B4-BE49-F238E27FC236}">
                <a16:creationId xmlns:a16="http://schemas.microsoft.com/office/drawing/2014/main" id="{D5130B31-3635-53DA-5E13-04CE10903CA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6981" y="4116896"/>
            <a:ext cx="3681531" cy="26209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65B6BFAE-38ED-8438-2C65-36EEA3526ED5}"/>
              </a:ext>
            </a:extLst>
          </p:cNvPr>
          <p:cNvSpPr txBox="1"/>
          <p:nvPr/>
        </p:nvSpPr>
        <p:spPr>
          <a:xfrm>
            <a:off x="191881" y="1424032"/>
            <a:ext cx="9630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2a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171EA86-3ED8-FEC7-BB9D-842DD95B373D}"/>
              </a:ext>
            </a:extLst>
          </p:cNvPr>
          <p:cNvSpPr/>
          <p:nvPr/>
        </p:nvSpPr>
        <p:spPr>
          <a:xfrm>
            <a:off x="2508069" y="5530723"/>
            <a:ext cx="896982" cy="50431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7A908B83-9338-973D-DE25-A45613363864}"/>
              </a:ext>
            </a:extLst>
          </p:cNvPr>
          <p:cNvSpPr/>
          <p:nvPr/>
        </p:nvSpPr>
        <p:spPr>
          <a:xfrm>
            <a:off x="2581297" y="2203773"/>
            <a:ext cx="928258" cy="3212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F6DB18A-DDB8-2F46-FC97-A51C8A8B722E}"/>
              </a:ext>
            </a:extLst>
          </p:cNvPr>
          <p:cNvSpPr/>
          <p:nvPr/>
        </p:nvSpPr>
        <p:spPr>
          <a:xfrm>
            <a:off x="3509555" y="2905469"/>
            <a:ext cx="928259" cy="3212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C497062-B1A3-1C2B-D8DE-B9A80EF5CFFC}"/>
              </a:ext>
            </a:extLst>
          </p:cNvPr>
          <p:cNvSpPr/>
          <p:nvPr/>
        </p:nvSpPr>
        <p:spPr>
          <a:xfrm>
            <a:off x="7506790" y="1777827"/>
            <a:ext cx="928960" cy="26185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F987D60-EA38-384F-4815-5DCCE405C551}"/>
              </a:ext>
            </a:extLst>
          </p:cNvPr>
          <p:cNvSpPr/>
          <p:nvPr/>
        </p:nvSpPr>
        <p:spPr>
          <a:xfrm>
            <a:off x="6606248" y="2524983"/>
            <a:ext cx="900541" cy="26185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70AC6F7-68FF-0493-5A98-41E3E84248B5}"/>
              </a:ext>
            </a:extLst>
          </p:cNvPr>
          <p:cNvSpPr/>
          <p:nvPr/>
        </p:nvSpPr>
        <p:spPr>
          <a:xfrm>
            <a:off x="7506790" y="2455311"/>
            <a:ext cx="928960" cy="26185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6D73591-EFBF-189A-C4E2-440773C5B410}"/>
              </a:ext>
            </a:extLst>
          </p:cNvPr>
          <p:cNvSpPr/>
          <p:nvPr/>
        </p:nvSpPr>
        <p:spPr>
          <a:xfrm>
            <a:off x="6706146" y="4720853"/>
            <a:ext cx="800643" cy="3212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9C5B47F-E8A4-1272-201C-6818CF9C95AB}"/>
              </a:ext>
            </a:extLst>
          </p:cNvPr>
          <p:cNvSpPr txBox="1"/>
          <p:nvPr/>
        </p:nvSpPr>
        <p:spPr>
          <a:xfrm>
            <a:off x="304801" y="226428"/>
            <a:ext cx="11695318" cy="996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trient restriction-activated Fra-2 promotes tumor progression </a:t>
            </a:r>
            <a:r>
              <a:rPr lang="en-US" sz="12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a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GF1R in miR-15a downmodulated pancreatic ductal adenocarcinoma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ian Luca Rampioni Vinciguerra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Marina Capece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Luca Reggiani Bonetti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iovanni Nigita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Federica Calore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ydney Rentsch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Paolo Magistri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Roberto Ballarin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Fabrizio di Benedetto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Rosario Distefano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Roberto Cirombella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rea Vecchione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Barbara Belletti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Gustavo Baldassarre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Francesca Lovat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Carlo M. Croce</a:t>
            </a:r>
            <a:r>
              <a:rPr lang="it-IT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3206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9A32F65-2801-9398-D870-23AECC925064}"/>
              </a:ext>
            </a:extLst>
          </p:cNvPr>
          <p:cNvSpPr txBox="1"/>
          <p:nvPr/>
        </p:nvSpPr>
        <p:spPr>
          <a:xfrm>
            <a:off x="121595" y="383962"/>
            <a:ext cx="9277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6f</a:t>
            </a:r>
          </a:p>
        </p:txBody>
      </p:sp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E7F5C097-CE10-2238-84D7-0C4B12DC01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6434" y="173736"/>
            <a:ext cx="5055326" cy="2672816"/>
          </a:xfrm>
          <a:prstGeom prst="rect">
            <a:avLst/>
          </a:prstGeom>
        </p:spPr>
      </p:pic>
      <p:pic>
        <p:nvPicPr>
          <p:cNvPr id="6" name="Picture 5" descr="A close-up of a line&#10;&#10;Description automatically generated">
            <a:extLst>
              <a:ext uri="{FF2B5EF4-FFF2-40B4-BE49-F238E27FC236}">
                <a16:creationId xmlns:a16="http://schemas.microsoft.com/office/drawing/2014/main" id="{2306BFD7-61BF-31FA-66F6-5DE507B7A75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6434" y="2895601"/>
            <a:ext cx="5055326" cy="1323895"/>
          </a:xfrm>
          <a:prstGeom prst="rect">
            <a:avLst/>
          </a:prstGeom>
        </p:spPr>
      </p:pic>
      <p:pic>
        <p:nvPicPr>
          <p:cNvPr id="8" name="Picture 7" descr="A test results of a dna&#10;&#10;Description automatically generated with medium confidence">
            <a:extLst>
              <a:ext uri="{FF2B5EF4-FFF2-40B4-BE49-F238E27FC236}">
                <a16:creationId xmlns:a16="http://schemas.microsoft.com/office/drawing/2014/main" id="{EF11524C-9B65-7321-0F2C-0917A3B156F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8845" y="173736"/>
            <a:ext cx="5055326" cy="254017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1D385E83-DC7A-4B8A-7A17-CDE1D652D19C}"/>
              </a:ext>
            </a:extLst>
          </p:cNvPr>
          <p:cNvSpPr/>
          <p:nvPr/>
        </p:nvSpPr>
        <p:spPr>
          <a:xfrm>
            <a:off x="2333897" y="909750"/>
            <a:ext cx="3257006" cy="296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D175A07-D6B1-7F6F-F3D9-4EE303A2E285}"/>
              </a:ext>
            </a:extLst>
          </p:cNvPr>
          <p:cNvSpPr/>
          <p:nvPr/>
        </p:nvSpPr>
        <p:spPr>
          <a:xfrm>
            <a:off x="1911531" y="3370375"/>
            <a:ext cx="3257006" cy="296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5BC0A6E-33D6-4C1E-4749-04D35BD42BD0}"/>
              </a:ext>
            </a:extLst>
          </p:cNvPr>
          <p:cNvSpPr/>
          <p:nvPr/>
        </p:nvSpPr>
        <p:spPr>
          <a:xfrm>
            <a:off x="7624356" y="1349830"/>
            <a:ext cx="3257006" cy="4180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76965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test&#10;&#10;Description automatically generated">
            <a:extLst>
              <a:ext uri="{FF2B5EF4-FFF2-40B4-BE49-F238E27FC236}">
                <a16:creationId xmlns:a16="http://schemas.microsoft.com/office/drawing/2014/main" id="{9FB67D74-B62B-BC7B-98E6-F27851B888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1872" y="162631"/>
            <a:ext cx="3131385" cy="252119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1A281A5-E7D2-6402-3E85-1854BD4285E6}"/>
              </a:ext>
            </a:extLst>
          </p:cNvPr>
          <p:cNvSpPr txBox="1"/>
          <p:nvPr/>
        </p:nvSpPr>
        <p:spPr>
          <a:xfrm>
            <a:off x="321892" y="366545"/>
            <a:ext cx="10704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1h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C928379-9DA6-4CA9-E89A-BF1F1FD3EE0D}"/>
              </a:ext>
            </a:extLst>
          </p:cNvPr>
          <p:cNvSpPr/>
          <p:nvPr/>
        </p:nvSpPr>
        <p:spPr>
          <a:xfrm>
            <a:off x="3047998" y="678973"/>
            <a:ext cx="583475" cy="28767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24C82F5-2985-EEF4-9F43-029069843BFA}"/>
              </a:ext>
            </a:extLst>
          </p:cNvPr>
          <p:cNvSpPr/>
          <p:nvPr/>
        </p:nvSpPr>
        <p:spPr>
          <a:xfrm>
            <a:off x="3004454" y="1509120"/>
            <a:ext cx="583475" cy="3422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 descr="A close-up of a paper&#10;&#10;Description automatically generated">
            <a:extLst>
              <a:ext uri="{FF2B5EF4-FFF2-40B4-BE49-F238E27FC236}">
                <a16:creationId xmlns:a16="http://schemas.microsoft.com/office/drawing/2014/main" id="{66843120-3E17-2089-B244-22C0093E993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7776" y="3122679"/>
            <a:ext cx="2443407" cy="2674979"/>
          </a:xfrm>
          <a:prstGeom prst="rect">
            <a:avLst/>
          </a:prstGeom>
        </p:spPr>
      </p:pic>
      <p:pic>
        <p:nvPicPr>
          <p:cNvPr id="10" name="Picture 9" descr="A close-up of a test&#10;&#10;Description automatically generated">
            <a:extLst>
              <a:ext uri="{FF2B5EF4-FFF2-40B4-BE49-F238E27FC236}">
                <a16:creationId xmlns:a16="http://schemas.microsoft.com/office/drawing/2014/main" id="{903264AF-B0B1-8593-23EE-049985DFB0B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1793" y="3122679"/>
            <a:ext cx="2443407" cy="2364247"/>
          </a:xfrm>
          <a:prstGeom prst="rect">
            <a:avLst/>
          </a:prstGeom>
        </p:spPr>
      </p:pic>
      <p:pic>
        <p:nvPicPr>
          <p:cNvPr id="12" name="Picture 11" descr="A close-up of a test tube&#10;&#10;Description automatically generated">
            <a:extLst>
              <a:ext uri="{FF2B5EF4-FFF2-40B4-BE49-F238E27FC236}">
                <a16:creationId xmlns:a16="http://schemas.microsoft.com/office/drawing/2014/main" id="{ECFB59A4-2C76-079A-90A4-31489CFBD4F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5810" y="3122679"/>
            <a:ext cx="2248061" cy="197670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A069E2D-BB79-21A2-427D-B61EB17D7F56}"/>
              </a:ext>
            </a:extLst>
          </p:cNvPr>
          <p:cNvSpPr txBox="1"/>
          <p:nvPr/>
        </p:nvSpPr>
        <p:spPr>
          <a:xfrm>
            <a:off x="321891" y="3153404"/>
            <a:ext cx="1060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3a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3C47624-D6A3-1C61-1063-69CB04696D85}"/>
              </a:ext>
            </a:extLst>
          </p:cNvPr>
          <p:cNvSpPr/>
          <p:nvPr/>
        </p:nvSpPr>
        <p:spPr>
          <a:xfrm>
            <a:off x="2886889" y="3859192"/>
            <a:ext cx="1153888" cy="3422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0BF408AC-0878-C4EA-CA6F-930DE9B8C3AB}"/>
              </a:ext>
            </a:extLst>
          </p:cNvPr>
          <p:cNvSpPr/>
          <p:nvPr/>
        </p:nvSpPr>
        <p:spPr>
          <a:xfrm>
            <a:off x="9030786" y="3962557"/>
            <a:ext cx="1153888" cy="3422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93DB8BA-8876-CD90-A8A8-BE22B2155D7E}"/>
              </a:ext>
            </a:extLst>
          </p:cNvPr>
          <p:cNvSpPr/>
          <p:nvPr/>
        </p:nvSpPr>
        <p:spPr>
          <a:xfrm>
            <a:off x="6322420" y="4254209"/>
            <a:ext cx="1323705" cy="3422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56521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AA64EB3-8CB5-4DC1-EEE8-E82DD5FB9155}"/>
              </a:ext>
            </a:extLst>
          </p:cNvPr>
          <p:cNvSpPr txBox="1"/>
          <p:nvPr/>
        </p:nvSpPr>
        <p:spPr>
          <a:xfrm>
            <a:off x="165137" y="201198"/>
            <a:ext cx="10575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3g</a:t>
            </a:r>
          </a:p>
        </p:txBody>
      </p:sp>
      <p:pic>
        <p:nvPicPr>
          <p:cNvPr id="4" name="Picture 3" descr="A close-up of a test results&#10;&#10;Description automatically generated">
            <a:extLst>
              <a:ext uri="{FF2B5EF4-FFF2-40B4-BE49-F238E27FC236}">
                <a16:creationId xmlns:a16="http://schemas.microsoft.com/office/drawing/2014/main" id="{0AF8DCED-E4BB-D410-D086-AF65863854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3753" y="201198"/>
            <a:ext cx="2223516" cy="2542096"/>
          </a:xfrm>
          <a:prstGeom prst="rect">
            <a:avLst/>
          </a:prstGeom>
        </p:spPr>
      </p:pic>
      <p:pic>
        <p:nvPicPr>
          <p:cNvPr id="6" name="Picture 5" descr="A close-up of a test&#10;&#10;Description automatically generated">
            <a:extLst>
              <a:ext uri="{FF2B5EF4-FFF2-40B4-BE49-F238E27FC236}">
                <a16:creationId xmlns:a16="http://schemas.microsoft.com/office/drawing/2014/main" id="{1AB369D4-93B5-B39E-FC66-6421812AC84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8941" y="201198"/>
            <a:ext cx="2267059" cy="2591878"/>
          </a:xfrm>
          <a:prstGeom prst="rect">
            <a:avLst/>
          </a:prstGeom>
        </p:spPr>
      </p:pic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0C9D3475-CF79-5BB2-24D4-A95324D0E72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7672" y="201198"/>
            <a:ext cx="4315023" cy="2591878"/>
          </a:xfrm>
          <a:prstGeom prst="rect">
            <a:avLst/>
          </a:prstGeom>
        </p:spPr>
      </p:pic>
      <p:pic>
        <p:nvPicPr>
          <p:cNvPr id="10" name="Picture 9" descr="A close-up of a test results&#10;&#10;Description automatically generated">
            <a:extLst>
              <a:ext uri="{FF2B5EF4-FFF2-40B4-BE49-F238E27FC236}">
                <a16:creationId xmlns:a16="http://schemas.microsoft.com/office/drawing/2014/main" id="{315ED2DD-3B3F-D23A-1574-E9165630688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3753" y="2949593"/>
            <a:ext cx="2223516" cy="2807835"/>
          </a:xfrm>
          <a:prstGeom prst="rect">
            <a:avLst/>
          </a:prstGeom>
        </p:spPr>
      </p:pic>
      <p:pic>
        <p:nvPicPr>
          <p:cNvPr id="12" name="Picture 11" descr="A close-up of a test&#10;&#10;Description automatically generated">
            <a:extLst>
              <a:ext uri="{FF2B5EF4-FFF2-40B4-BE49-F238E27FC236}">
                <a16:creationId xmlns:a16="http://schemas.microsoft.com/office/drawing/2014/main" id="{6DC53219-BE0E-15D2-A853-5FE047604FC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8941" y="2949593"/>
            <a:ext cx="2737322" cy="2768252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ABC751CE-6B81-00EA-424A-08D90458FE31}"/>
              </a:ext>
            </a:extLst>
          </p:cNvPr>
          <p:cNvSpPr/>
          <p:nvPr/>
        </p:nvSpPr>
        <p:spPr>
          <a:xfrm>
            <a:off x="2399209" y="1002781"/>
            <a:ext cx="1092928" cy="3422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F9C71C5-FA7F-60A2-E14D-8C53BEF94FBD}"/>
              </a:ext>
            </a:extLst>
          </p:cNvPr>
          <p:cNvSpPr/>
          <p:nvPr/>
        </p:nvSpPr>
        <p:spPr>
          <a:xfrm>
            <a:off x="6783973" y="1860573"/>
            <a:ext cx="1132118" cy="3422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8C9C658C-FC64-CAB4-D4FB-7AEC62C156AF}"/>
              </a:ext>
            </a:extLst>
          </p:cNvPr>
          <p:cNvSpPr/>
          <p:nvPr/>
        </p:nvSpPr>
        <p:spPr>
          <a:xfrm>
            <a:off x="8164281" y="1011489"/>
            <a:ext cx="1132118" cy="3422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F010121-05CC-7C24-EC6E-799F98D8C351}"/>
              </a:ext>
            </a:extLst>
          </p:cNvPr>
          <p:cNvSpPr/>
          <p:nvPr/>
        </p:nvSpPr>
        <p:spPr>
          <a:xfrm>
            <a:off x="3923207" y="1356332"/>
            <a:ext cx="1132118" cy="3422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E90CD593-BAD0-434A-C898-C5E8F11FDE64}"/>
              </a:ext>
            </a:extLst>
          </p:cNvPr>
          <p:cNvSpPr/>
          <p:nvPr/>
        </p:nvSpPr>
        <p:spPr>
          <a:xfrm>
            <a:off x="3966748" y="4100952"/>
            <a:ext cx="1132118" cy="3422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DAFFF0E-68A9-771D-5BD7-CBB96F4F418B}"/>
              </a:ext>
            </a:extLst>
          </p:cNvPr>
          <p:cNvSpPr/>
          <p:nvPr/>
        </p:nvSpPr>
        <p:spPr>
          <a:xfrm>
            <a:off x="3923207" y="3376746"/>
            <a:ext cx="1132118" cy="3422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53F8EC14-A46B-B4B3-D49F-248C0FEB95E3}"/>
              </a:ext>
            </a:extLst>
          </p:cNvPr>
          <p:cNvSpPr/>
          <p:nvPr/>
        </p:nvSpPr>
        <p:spPr>
          <a:xfrm>
            <a:off x="2251917" y="4144497"/>
            <a:ext cx="1132118" cy="3422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26043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CE99A57-35B3-FF93-6CC2-538EFE185C45}"/>
              </a:ext>
            </a:extLst>
          </p:cNvPr>
          <p:cNvSpPr txBox="1"/>
          <p:nvPr/>
        </p:nvSpPr>
        <p:spPr>
          <a:xfrm>
            <a:off x="165137" y="201198"/>
            <a:ext cx="10095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3i</a:t>
            </a:r>
          </a:p>
        </p:txBody>
      </p:sp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FDFC7AA8-DED1-4152-898C-C03AB0CD67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9156" y="201198"/>
            <a:ext cx="2314737" cy="1740813"/>
          </a:xfrm>
          <a:prstGeom prst="rect">
            <a:avLst/>
          </a:prstGeom>
        </p:spPr>
      </p:pic>
      <p:pic>
        <p:nvPicPr>
          <p:cNvPr id="6" name="Picture 5" descr="A close-up of a test&#10;&#10;Description automatically generated">
            <a:extLst>
              <a:ext uri="{FF2B5EF4-FFF2-40B4-BE49-F238E27FC236}">
                <a16:creationId xmlns:a16="http://schemas.microsoft.com/office/drawing/2014/main" id="{B02598E0-7F5A-3F27-4942-6BBD877F8F5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9080" y="201198"/>
            <a:ext cx="2240246" cy="1845316"/>
          </a:xfrm>
          <a:prstGeom prst="rect">
            <a:avLst/>
          </a:prstGeom>
        </p:spPr>
      </p:pic>
      <p:pic>
        <p:nvPicPr>
          <p:cNvPr id="8" name="Picture 7" descr="A close-up of a test results&#10;&#10;Description automatically generated">
            <a:extLst>
              <a:ext uri="{FF2B5EF4-FFF2-40B4-BE49-F238E27FC236}">
                <a16:creationId xmlns:a16="http://schemas.microsoft.com/office/drawing/2014/main" id="{D81010C7-7B3F-6278-B3AC-C567C1182B1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4513" y="201198"/>
            <a:ext cx="2335018" cy="1923381"/>
          </a:xfrm>
          <a:prstGeom prst="rect">
            <a:avLst/>
          </a:prstGeom>
        </p:spPr>
      </p:pic>
      <p:pic>
        <p:nvPicPr>
          <p:cNvPr id="10" name="Picture 9" descr="A close-up of a test results&#10;&#10;Description automatically generated">
            <a:extLst>
              <a:ext uri="{FF2B5EF4-FFF2-40B4-BE49-F238E27FC236}">
                <a16:creationId xmlns:a16="http://schemas.microsoft.com/office/drawing/2014/main" id="{C67E7049-4BAE-F8A0-29AF-534303A2296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4718" y="201198"/>
            <a:ext cx="3001191" cy="2140173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3B43B19C-217C-FE42-C2CC-9EE11179A497}"/>
              </a:ext>
            </a:extLst>
          </p:cNvPr>
          <p:cNvSpPr/>
          <p:nvPr/>
        </p:nvSpPr>
        <p:spPr>
          <a:xfrm>
            <a:off x="1750424" y="722517"/>
            <a:ext cx="679267" cy="28767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480AB15-06F1-D18B-8AAC-2D7C736BDAD2}"/>
              </a:ext>
            </a:extLst>
          </p:cNvPr>
          <p:cNvSpPr/>
          <p:nvPr/>
        </p:nvSpPr>
        <p:spPr>
          <a:xfrm>
            <a:off x="7977051" y="822811"/>
            <a:ext cx="625929" cy="25705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D6150E36-0D39-48DE-72D3-878F989D0600}"/>
              </a:ext>
            </a:extLst>
          </p:cNvPr>
          <p:cNvSpPr/>
          <p:nvPr/>
        </p:nvSpPr>
        <p:spPr>
          <a:xfrm>
            <a:off x="10924904" y="678972"/>
            <a:ext cx="679267" cy="28767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35C1CC3-2043-014C-E333-1F49146EB015}"/>
              </a:ext>
            </a:extLst>
          </p:cNvPr>
          <p:cNvSpPr/>
          <p:nvPr/>
        </p:nvSpPr>
        <p:spPr>
          <a:xfrm>
            <a:off x="10924903" y="1444424"/>
            <a:ext cx="679267" cy="28767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898945B-50A3-47D4-699E-242D1D07D6E2}"/>
              </a:ext>
            </a:extLst>
          </p:cNvPr>
          <p:cNvSpPr/>
          <p:nvPr/>
        </p:nvSpPr>
        <p:spPr>
          <a:xfrm>
            <a:off x="5496707" y="470263"/>
            <a:ext cx="679267" cy="18789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D2535EC-4393-6B40-DCE3-A239745D423E}"/>
              </a:ext>
            </a:extLst>
          </p:cNvPr>
          <p:cNvSpPr/>
          <p:nvPr/>
        </p:nvSpPr>
        <p:spPr>
          <a:xfrm>
            <a:off x="7926977" y="1271284"/>
            <a:ext cx="676002" cy="25705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8" name="Picture 17" descr="A paper with writing on it&#10;&#10;Description automatically generated">
            <a:extLst>
              <a:ext uri="{FF2B5EF4-FFF2-40B4-BE49-F238E27FC236}">
                <a16:creationId xmlns:a16="http://schemas.microsoft.com/office/drawing/2014/main" id="{164B0F3E-DA2F-4A9B-72FD-660A699A4E7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4603" y="3040840"/>
            <a:ext cx="5178148" cy="1193632"/>
          </a:xfrm>
          <a:prstGeom prst="rect">
            <a:avLst/>
          </a:prstGeom>
        </p:spPr>
      </p:pic>
      <p:pic>
        <p:nvPicPr>
          <p:cNvPr id="20" name="Picture 19" descr="A close-up of a paper&#10;&#10;Description automatically generated">
            <a:extLst>
              <a:ext uri="{FF2B5EF4-FFF2-40B4-BE49-F238E27FC236}">
                <a16:creationId xmlns:a16="http://schemas.microsoft.com/office/drawing/2014/main" id="{DDFBD387-EDE6-9CA9-8474-BC699D10CF0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2332" y="4366718"/>
            <a:ext cx="5170419" cy="1795606"/>
          </a:xfrm>
          <a:prstGeom prst="rect">
            <a:avLst/>
          </a:prstGeom>
        </p:spPr>
      </p:pic>
      <p:pic>
        <p:nvPicPr>
          <p:cNvPr id="22" name="Picture 21" descr="A close-up of a test&#10;&#10;Description automatically generated">
            <a:extLst>
              <a:ext uri="{FF2B5EF4-FFF2-40B4-BE49-F238E27FC236}">
                <a16:creationId xmlns:a16="http://schemas.microsoft.com/office/drawing/2014/main" id="{7E710031-28DF-5AED-6510-76934BE42DE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0706" y="3252469"/>
            <a:ext cx="5178148" cy="266518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AE0BA92D-957D-9F35-D6F0-606F159B2DAA}"/>
              </a:ext>
            </a:extLst>
          </p:cNvPr>
          <p:cNvSpPr txBox="1"/>
          <p:nvPr/>
        </p:nvSpPr>
        <p:spPr>
          <a:xfrm>
            <a:off x="163146" y="3083192"/>
            <a:ext cx="1060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4a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D78D1647-9878-5E48-8691-30FA305C8786}"/>
              </a:ext>
            </a:extLst>
          </p:cNvPr>
          <p:cNvSpPr/>
          <p:nvPr/>
        </p:nvSpPr>
        <p:spPr>
          <a:xfrm>
            <a:off x="2239700" y="3252469"/>
            <a:ext cx="3333785" cy="3304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9475D21D-4C9B-C030-85F0-C527809E0890}"/>
              </a:ext>
            </a:extLst>
          </p:cNvPr>
          <p:cNvSpPr/>
          <p:nvPr/>
        </p:nvSpPr>
        <p:spPr>
          <a:xfrm>
            <a:off x="2168437" y="4754697"/>
            <a:ext cx="3389234" cy="3304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902DF84E-4DF8-3BDF-3628-4B257157D185}"/>
              </a:ext>
            </a:extLst>
          </p:cNvPr>
          <p:cNvSpPr/>
          <p:nvPr/>
        </p:nvSpPr>
        <p:spPr>
          <a:xfrm>
            <a:off x="7602021" y="4001385"/>
            <a:ext cx="3475281" cy="3304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72567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30144C5-C657-1C2F-AC41-F524A3D50379}"/>
              </a:ext>
            </a:extLst>
          </p:cNvPr>
          <p:cNvSpPr txBox="1"/>
          <p:nvPr/>
        </p:nvSpPr>
        <p:spPr>
          <a:xfrm>
            <a:off x="197981" y="244198"/>
            <a:ext cx="10704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4d</a:t>
            </a:r>
          </a:p>
        </p:txBody>
      </p:sp>
      <p:pic>
        <p:nvPicPr>
          <p:cNvPr id="4" name="Picture 3" descr="A blue background with black text&#10;&#10;Description automatically generated with medium confidence">
            <a:extLst>
              <a:ext uri="{FF2B5EF4-FFF2-40B4-BE49-F238E27FC236}">
                <a16:creationId xmlns:a16="http://schemas.microsoft.com/office/drawing/2014/main" id="{8A14D6FB-2D15-167D-5D3B-4CF44FE0BC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5915" y="167205"/>
            <a:ext cx="4600085" cy="1434805"/>
          </a:xfrm>
          <a:prstGeom prst="rect">
            <a:avLst/>
          </a:prstGeom>
        </p:spPr>
      </p:pic>
      <p:pic>
        <p:nvPicPr>
          <p:cNvPr id="6" name="Picture 5" descr="A blue background with black lines&#10;&#10;Description automatically generated with medium confidence">
            <a:extLst>
              <a:ext uri="{FF2B5EF4-FFF2-40B4-BE49-F238E27FC236}">
                <a16:creationId xmlns:a16="http://schemas.microsoft.com/office/drawing/2014/main" id="{F01311F3-8CEC-A21A-1833-FCAEF4B3E3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3513" y="167205"/>
            <a:ext cx="4600085" cy="1391809"/>
          </a:xfrm>
          <a:prstGeom prst="rect">
            <a:avLst/>
          </a:prstGeom>
        </p:spPr>
      </p:pic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2C7CC64A-61B0-3EB7-80FE-25D04B9121D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5915" y="1685327"/>
            <a:ext cx="4600085" cy="2061034"/>
          </a:xfrm>
          <a:prstGeom prst="rect">
            <a:avLst/>
          </a:prstGeom>
        </p:spPr>
      </p:pic>
      <p:pic>
        <p:nvPicPr>
          <p:cNvPr id="10" name="Picture 9" descr="A close-up of a test&#10;&#10;Description automatically generated">
            <a:extLst>
              <a:ext uri="{FF2B5EF4-FFF2-40B4-BE49-F238E27FC236}">
                <a16:creationId xmlns:a16="http://schemas.microsoft.com/office/drawing/2014/main" id="{C67AC5AE-F63F-E2B5-92EC-F06DD18F0FD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3513" y="1685327"/>
            <a:ext cx="4600085" cy="2334504"/>
          </a:xfrm>
          <a:prstGeom prst="rect">
            <a:avLst/>
          </a:prstGeom>
        </p:spPr>
      </p:pic>
      <p:pic>
        <p:nvPicPr>
          <p:cNvPr id="12" name="Picture 11" descr="A close-up of a test&#10;&#10;Description automatically generated">
            <a:extLst>
              <a:ext uri="{FF2B5EF4-FFF2-40B4-BE49-F238E27FC236}">
                <a16:creationId xmlns:a16="http://schemas.microsoft.com/office/drawing/2014/main" id="{A346DC4C-1B1B-C54C-5D7D-1FD0659CFCF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5915" y="3829678"/>
            <a:ext cx="4600085" cy="2334504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E3F7960A-120D-2193-CD4A-CBA1D08C50C8}"/>
              </a:ext>
            </a:extLst>
          </p:cNvPr>
          <p:cNvSpPr/>
          <p:nvPr/>
        </p:nvSpPr>
        <p:spPr>
          <a:xfrm>
            <a:off x="2751907" y="792745"/>
            <a:ext cx="2255522" cy="3304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1480DCB3-6A4D-E0CA-9CB4-D5CCD4DDD37A}"/>
              </a:ext>
            </a:extLst>
          </p:cNvPr>
          <p:cNvSpPr/>
          <p:nvPr/>
        </p:nvSpPr>
        <p:spPr>
          <a:xfrm>
            <a:off x="7136676" y="653623"/>
            <a:ext cx="796833" cy="3304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850340A-7F41-AC0F-A07F-CF51A228C952}"/>
              </a:ext>
            </a:extLst>
          </p:cNvPr>
          <p:cNvSpPr/>
          <p:nvPr/>
        </p:nvSpPr>
        <p:spPr>
          <a:xfrm>
            <a:off x="2290354" y="2290620"/>
            <a:ext cx="2882538" cy="2784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60C3441-1094-2AD1-18DF-9F15508139E6}"/>
              </a:ext>
            </a:extLst>
          </p:cNvPr>
          <p:cNvSpPr/>
          <p:nvPr/>
        </p:nvSpPr>
        <p:spPr>
          <a:xfrm>
            <a:off x="7173577" y="2587497"/>
            <a:ext cx="751223" cy="32987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50A3482-CCC5-2AF2-03F8-718B427A48D7}"/>
              </a:ext>
            </a:extLst>
          </p:cNvPr>
          <p:cNvSpPr/>
          <p:nvPr/>
        </p:nvSpPr>
        <p:spPr>
          <a:xfrm>
            <a:off x="2899954" y="4840307"/>
            <a:ext cx="2211978" cy="27841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67060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1976BFC-9E7C-086E-8AA0-A71F6B119BBC}"/>
              </a:ext>
            </a:extLst>
          </p:cNvPr>
          <p:cNvSpPr txBox="1"/>
          <p:nvPr/>
        </p:nvSpPr>
        <p:spPr>
          <a:xfrm>
            <a:off x="197981" y="244198"/>
            <a:ext cx="1060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6a</a:t>
            </a:r>
          </a:p>
        </p:txBody>
      </p:sp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59EE47EB-7C5F-62EA-DAF8-EF06B3E4E8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7266" y="244198"/>
            <a:ext cx="3491523" cy="2289996"/>
          </a:xfrm>
          <a:prstGeom prst="rect">
            <a:avLst/>
          </a:prstGeom>
        </p:spPr>
      </p:pic>
      <p:pic>
        <p:nvPicPr>
          <p:cNvPr id="6" name="Picture 5" descr="A close-up of a test&#10;&#10;Description automatically generated">
            <a:extLst>
              <a:ext uri="{FF2B5EF4-FFF2-40B4-BE49-F238E27FC236}">
                <a16:creationId xmlns:a16="http://schemas.microsoft.com/office/drawing/2014/main" id="{59E4E69D-0084-34DB-6612-1F86825E162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8777" y="244198"/>
            <a:ext cx="3488871" cy="2374647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DAF3CDAF-A892-40EB-1BB1-31FB3265A0E1}"/>
              </a:ext>
            </a:extLst>
          </p:cNvPr>
          <p:cNvSpPr/>
          <p:nvPr/>
        </p:nvSpPr>
        <p:spPr>
          <a:xfrm>
            <a:off x="2342605" y="705659"/>
            <a:ext cx="1767841" cy="3304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4631F70-5732-AADD-6AB0-62D099F47AC2}"/>
              </a:ext>
            </a:extLst>
          </p:cNvPr>
          <p:cNvSpPr/>
          <p:nvPr/>
        </p:nvSpPr>
        <p:spPr>
          <a:xfrm>
            <a:off x="2342605" y="1332368"/>
            <a:ext cx="862149" cy="3304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A1A55C0-9A50-2CBE-41AB-ED9EFEABE105}"/>
              </a:ext>
            </a:extLst>
          </p:cNvPr>
          <p:cNvSpPr/>
          <p:nvPr/>
        </p:nvSpPr>
        <p:spPr>
          <a:xfrm>
            <a:off x="6966857" y="1444540"/>
            <a:ext cx="896984" cy="3304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 descr="A white board with black lines and text&#10;&#10;Description automatically generated">
            <a:extLst>
              <a:ext uri="{FF2B5EF4-FFF2-40B4-BE49-F238E27FC236}">
                <a16:creationId xmlns:a16="http://schemas.microsoft.com/office/drawing/2014/main" id="{33CB9106-EB30-3144-C029-B73D3748284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7597" y="3295108"/>
            <a:ext cx="4856117" cy="1888096"/>
          </a:xfrm>
          <a:prstGeom prst="rect">
            <a:avLst/>
          </a:prstGeom>
        </p:spPr>
      </p:pic>
      <p:pic>
        <p:nvPicPr>
          <p:cNvPr id="13" name="Picture 12" descr="A close-up of a test&#10;&#10;Description automatically generated">
            <a:extLst>
              <a:ext uri="{FF2B5EF4-FFF2-40B4-BE49-F238E27FC236}">
                <a16:creationId xmlns:a16="http://schemas.microsoft.com/office/drawing/2014/main" id="{84105411-36C5-2E50-A24C-C6B85A9745A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44640" y="3295108"/>
            <a:ext cx="4856117" cy="198327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EB7FD4D-9316-8B06-7C0B-9EE6BA370F92}"/>
              </a:ext>
            </a:extLst>
          </p:cNvPr>
          <p:cNvSpPr txBox="1"/>
          <p:nvPr/>
        </p:nvSpPr>
        <p:spPr>
          <a:xfrm>
            <a:off x="197981" y="3259723"/>
            <a:ext cx="10463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7c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65A6BB6-AA49-E968-F338-4113F078D1DF}"/>
              </a:ext>
            </a:extLst>
          </p:cNvPr>
          <p:cNvSpPr/>
          <p:nvPr/>
        </p:nvSpPr>
        <p:spPr>
          <a:xfrm>
            <a:off x="1881049" y="3952253"/>
            <a:ext cx="3129031" cy="3304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EF4CD2D-B71D-81C4-9D54-C8834C4BE3DA}"/>
              </a:ext>
            </a:extLst>
          </p:cNvPr>
          <p:cNvSpPr/>
          <p:nvPr/>
        </p:nvSpPr>
        <p:spPr>
          <a:xfrm>
            <a:off x="7249883" y="4248084"/>
            <a:ext cx="3287488" cy="3152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05903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490476F-89FA-419D-5770-2AE612D16A0E}"/>
              </a:ext>
            </a:extLst>
          </p:cNvPr>
          <p:cNvSpPr txBox="1"/>
          <p:nvPr/>
        </p:nvSpPr>
        <p:spPr>
          <a:xfrm>
            <a:off x="84770" y="255266"/>
            <a:ext cx="10463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8c</a:t>
            </a:r>
          </a:p>
        </p:txBody>
      </p:sp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97C883D4-7D32-1472-CBA7-C9A5140E6C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1719" y="255266"/>
            <a:ext cx="2327801" cy="2265226"/>
          </a:xfrm>
          <a:prstGeom prst="rect">
            <a:avLst/>
          </a:prstGeom>
        </p:spPr>
      </p:pic>
      <p:pic>
        <p:nvPicPr>
          <p:cNvPr id="6" name="Picture 5" descr="A close-up of a paper&#10;&#10;Description automatically generated">
            <a:extLst>
              <a:ext uri="{FF2B5EF4-FFF2-40B4-BE49-F238E27FC236}">
                <a16:creationId xmlns:a16="http://schemas.microsoft.com/office/drawing/2014/main" id="{2C5B3F25-5174-EA67-C7E5-2AB282204B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0092" y="255266"/>
            <a:ext cx="2469075" cy="1381945"/>
          </a:xfrm>
          <a:prstGeom prst="rect">
            <a:avLst/>
          </a:prstGeom>
        </p:spPr>
      </p:pic>
      <p:pic>
        <p:nvPicPr>
          <p:cNvPr id="8" name="Picture 7" descr="A close-up of a test results&#10;&#10;Description automatically generated">
            <a:extLst>
              <a:ext uri="{FF2B5EF4-FFF2-40B4-BE49-F238E27FC236}">
                <a16:creationId xmlns:a16="http://schemas.microsoft.com/office/drawing/2014/main" id="{A9D6FB9A-8909-9C52-EF40-C1875617ED0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9739" y="255266"/>
            <a:ext cx="2393598" cy="2257395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854B05B0-A072-B593-065E-475262FFE22A}"/>
              </a:ext>
            </a:extLst>
          </p:cNvPr>
          <p:cNvSpPr/>
          <p:nvPr/>
        </p:nvSpPr>
        <p:spPr>
          <a:xfrm>
            <a:off x="7232469" y="966651"/>
            <a:ext cx="1014547" cy="41801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C1C77F0-33C5-FBE9-6EB2-E9319AB4F2C8}"/>
              </a:ext>
            </a:extLst>
          </p:cNvPr>
          <p:cNvSpPr/>
          <p:nvPr/>
        </p:nvSpPr>
        <p:spPr>
          <a:xfrm>
            <a:off x="7232469" y="1428205"/>
            <a:ext cx="1014547" cy="41801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ADE9C11-7592-4596-FA46-74BE9E39FBCA}"/>
              </a:ext>
            </a:extLst>
          </p:cNvPr>
          <p:cNvSpPr/>
          <p:nvPr/>
        </p:nvSpPr>
        <p:spPr>
          <a:xfrm>
            <a:off x="4406537" y="761999"/>
            <a:ext cx="1014547" cy="41801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4948583-9AFD-0F4F-D65C-81FC0DA95A91}"/>
              </a:ext>
            </a:extLst>
          </p:cNvPr>
          <p:cNvSpPr/>
          <p:nvPr/>
        </p:nvSpPr>
        <p:spPr>
          <a:xfrm>
            <a:off x="1579930" y="661851"/>
            <a:ext cx="1014547" cy="20900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68F23D64-ABA5-CBBF-12D3-A5E436168110}"/>
              </a:ext>
            </a:extLst>
          </p:cNvPr>
          <p:cNvSpPr/>
          <p:nvPr/>
        </p:nvSpPr>
        <p:spPr>
          <a:xfrm>
            <a:off x="1579929" y="1750423"/>
            <a:ext cx="1014547" cy="30044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95AF668-C1AF-822F-9BC6-4E38D71CFCA0}"/>
              </a:ext>
            </a:extLst>
          </p:cNvPr>
          <p:cNvSpPr txBox="1"/>
          <p:nvPr/>
        </p:nvSpPr>
        <p:spPr>
          <a:xfrm>
            <a:off x="84770" y="3272787"/>
            <a:ext cx="10704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8d</a:t>
            </a:r>
          </a:p>
        </p:txBody>
      </p:sp>
      <p:pic>
        <p:nvPicPr>
          <p:cNvPr id="16" name="Picture 15" descr="A close-up of a test&#10;&#10;Description automatically generated">
            <a:extLst>
              <a:ext uri="{FF2B5EF4-FFF2-40B4-BE49-F238E27FC236}">
                <a16:creationId xmlns:a16="http://schemas.microsoft.com/office/drawing/2014/main" id="{55C21823-203A-8AF6-84CC-4D4E8FAF791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1061" y="3200941"/>
            <a:ext cx="2478459" cy="2337427"/>
          </a:xfrm>
          <a:prstGeom prst="rect">
            <a:avLst/>
          </a:prstGeom>
        </p:spPr>
      </p:pic>
      <p:pic>
        <p:nvPicPr>
          <p:cNvPr id="18" name="Picture 17" descr="A close-up of a test&#10;&#10;Description automatically generated">
            <a:extLst>
              <a:ext uri="{FF2B5EF4-FFF2-40B4-BE49-F238E27FC236}">
                <a16:creationId xmlns:a16="http://schemas.microsoft.com/office/drawing/2014/main" id="{4480B8C4-A5B5-DA02-A737-5D55C0371D2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5390" y="3200941"/>
            <a:ext cx="2440721" cy="2301837"/>
          </a:xfrm>
          <a:prstGeom prst="rect">
            <a:avLst/>
          </a:prstGeom>
        </p:spPr>
      </p:pic>
      <p:pic>
        <p:nvPicPr>
          <p:cNvPr id="20" name="Picture 19" descr="A close-up of a blue screen&#10;&#10;Description automatically generated">
            <a:extLst>
              <a:ext uri="{FF2B5EF4-FFF2-40B4-BE49-F238E27FC236}">
                <a16:creationId xmlns:a16="http://schemas.microsoft.com/office/drawing/2014/main" id="{08E1F60E-2E51-EE50-CB6E-7180120C5D5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0290" y="5617352"/>
            <a:ext cx="3320141" cy="1140506"/>
          </a:xfrm>
          <a:prstGeom prst="rect">
            <a:avLst/>
          </a:prstGeom>
        </p:spPr>
      </p:pic>
      <p:pic>
        <p:nvPicPr>
          <p:cNvPr id="22" name="Picture 21" descr="A close-up of a test&#10;&#10;Description automatically generated">
            <a:extLst>
              <a:ext uri="{FF2B5EF4-FFF2-40B4-BE49-F238E27FC236}">
                <a16:creationId xmlns:a16="http://schemas.microsoft.com/office/drawing/2014/main" id="{31CBB8FE-E7D5-7EAF-671E-F7D58B20FB6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0733" y="3193870"/>
            <a:ext cx="2280387" cy="2684341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FAF12C84-2335-1076-6D3D-CEEEC71E1CF7}"/>
              </a:ext>
            </a:extLst>
          </p:cNvPr>
          <p:cNvSpPr/>
          <p:nvPr/>
        </p:nvSpPr>
        <p:spPr>
          <a:xfrm>
            <a:off x="7739741" y="4327034"/>
            <a:ext cx="1014547" cy="31463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9DD48214-20B7-D3BF-8001-CCB9225434A2}"/>
              </a:ext>
            </a:extLst>
          </p:cNvPr>
          <p:cNvSpPr/>
          <p:nvPr/>
        </p:nvSpPr>
        <p:spPr>
          <a:xfrm>
            <a:off x="7739740" y="4714566"/>
            <a:ext cx="1014547" cy="31463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328187E7-2C0C-BD5E-8768-E96AD0357AC1}"/>
              </a:ext>
            </a:extLst>
          </p:cNvPr>
          <p:cNvSpPr/>
          <p:nvPr/>
        </p:nvSpPr>
        <p:spPr>
          <a:xfrm>
            <a:off x="5001602" y="4049486"/>
            <a:ext cx="1014547" cy="27754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BC924AD-D7D6-5089-2DFC-109F7AD90FA2}"/>
              </a:ext>
            </a:extLst>
          </p:cNvPr>
          <p:cNvSpPr/>
          <p:nvPr/>
        </p:nvSpPr>
        <p:spPr>
          <a:xfrm>
            <a:off x="3544390" y="6230754"/>
            <a:ext cx="1062976" cy="31463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A868414D-9C1E-09AA-F3B5-2C0D63D116B7}"/>
              </a:ext>
            </a:extLst>
          </p:cNvPr>
          <p:cNvSpPr/>
          <p:nvPr/>
        </p:nvSpPr>
        <p:spPr>
          <a:xfrm>
            <a:off x="2475970" y="5091719"/>
            <a:ext cx="1014547" cy="31463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30544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BE347ED-F15B-290A-8261-60965F0A8C50}"/>
              </a:ext>
            </a:extLst>
          </p:cNvPr>
          <p:cNvSpPr txBox="1"/>
          <p:nvPr/>
        </p:nvSpPr>
        <p:spPr>
          <a:xfrm>
            <a:off x="102187" y="337999"/>
            <a:ext cx="10463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9c</a:t>
            </a:r>
          </a:p>
        </p:txBody>
      </p:sp>
      <p:pic>
        <p:nvPicPr>
          <p:cNvPr id="4" name="Picture 3" descr="A close-up of a test results&#10;&#10;Description automatically generated">
            <a:extLst>
              <a:ext uri="{FF2B5EF4-FFF2-40B4-BE49-F238E27FC236}">
                <a16:creationId xmlns:a16="http://schemas.microsoft.com/office/drawing/2014/main" id="{B719DE9F-B21F-B721-24A3-247911FA2E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6771" y="153706"/>
            <a:ext cx="2884932" cy="1965726"/>
          </a:xfrm>
          <a:prstGeom prst="rect">
            <a:avLst/>
          </a:prstGeom>
        </p:spPr>
      </p:pic>
      <p:pic>
        <p:nvPicPr>
          <p:cNvPr id="6" name="Picture 5" descr="A close-up of a blue board&#10;&#10;Description automatically generated">
            <a:extLst>
              <a:ext uri="{FF2B5EF4-FFF2-40B4-BE49-F238E27FC236}">
                <a16:creationId xmlns:a16="http://schemas.microsoft.com/office/drawing/2014/main" id="{2D7169B9-ACC0-9FC5-2A1D-BEEE395AFFC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3075" y="153706"/>
            <a:ext cx="2291649" cy="1965726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13C25CFE-F81A-D957-1F2C-C82BFF9CD5B7}"/>
              </a:ext>
            </a:extLst>
          </p:cNvPr>
          <p:cNvSpPr/>
          <p:nvPr/>
        </p:nvSpPr>
        <p:spPr>
          <a:xfrm>
            <a:off x="2589328" y="997795"/>
            <a:ext cx="1381781" cy="27754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D49B4B4-09D6-F58C-B991-784179938876}"/>
              </a:ext>
            </a:extLst>
          </p:cNvPr>
          <p:cNvSpPr/>
          <p:nvPr/>
        </p:nvSpPr>
        <p:spPr>
          <a:xfrm>
            <a:off x="2563201" y="1593667"/>
            <a:ext cx="1381781" cy="37446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449103C-69AA-EC91-00C9-4288E695B7C4}"/>
              </a:ext>
            </a:extLst>
          </p:cNvPr>
          <p:cNvSpPr/>
          <p:nvPr/>
        </p:nvSpPr>
        <p:spPr>
          <a:xfrm>
            <a:off x="5606846" y="1010856"/>
            <a:ext cx="1381781" cy="37446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 descr="A close-up of a test&#10;&#10;Description automatically generated">
            <a:extLst>
              <a:ext uri="{FF2B5EF4-FFF2-40B4-BE49-F238E27FC236}">
                <a16:creationId xmlns:a16="http://schemas.microsoft.com/office/drawing/2014/main" id="{265211C8-AE9C-D9E8-52AD-22CE3564424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8183" y="3487231"/>
            <a:ext cx="4884418" cy="2232245"/>
          </a:xfrm>
          <a:prstGeom prst="rect">
            <a:avLst/>
          </a:prstGeom>
        </p:spPr>
      </p:pic>
      <p:pic>
        <p:nvPicPr>
          <p:cNvPr id="13" name="Picture 12" descr="A close-up of a test&#10;&#10;Description automatically generated">
            <a:extLst>
              <a:ext uri="{FF2B5EF4-FFF2-40B4-BE49-F238E27FC236}">
                <a16:creationId xmlns:a16="http://schemas.microsoft.com/office/drawing/2014/main" id="{306F4DFF-BD54-2BF8-4A2F-4586C8BA90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6771" y="4603354"/>
            <a:ext cx="4992406" cy="1908861"/>
          </a:xfrm>
          <a:prstGeom prst="rect">
            <a:avLst/>
          </a:prstGeom>
        </p:spPr>
      </p:pic>
      <p:pic>
        <p:nvPicPr>
          <p:cNvPr id="15" name="Picture 14" descr="A close-up of a test&#10;&#10;Description automatically generated">
            <a:extLst>
              <a:ext uri="{FF2B5EF4-FFF2-40B4-BE49-F238E27FC236}">
                <a16:creationId xmlns:a16="http://schemas.microsoft.com/office/drawing/2014/main" id="{87980B6B-A06B-59F6-7A58-9CC39009560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6771" y="2573001"/>
            <a:ext cx="4992406" cy="1908861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95FCE9C0-0452-19CA-9AA4-D8FD19A137CD}"/>
              </a:ext>
            </a:extLst>
          </p:cNvPr>
          <p:cNvSpPr txBox="1"/>
          <p:nvPr/>
        </p:nvSpPr>
        <p:spPr>
          <a:xfrm>
            <a:off x="102187" y="2772045"/>
            <a:ext cx="11666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10e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44FA4647-3CCB-BC3A-8A6E-A09CEB7F7351}"/>
              </a:ext>
            </a:extLst>
          </p:cNvPr>
          <p:cNvSpPr/>
          <p:nvPr/>
        </p:nvSpPr>
        <p:spPr>
          <a:xfrm>
            <a:off x="2162606" y="2941850"/>
            <a:ext cx="3444240" cy="37446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DB1CC073-4DC0-52A5-C181-DED27BD58378}"/>
              </a:ext>
            </a:extLst>
          </p:cNvPr>
          <p:cNvSpPr/>
          <p:nvPr/>
        </p:nvSpPr>
        <p:spPr>
          <a:xfrm>
            <a:off x="2062458" y="5672971"/>
            <a:ext cx="3444240" cy="37446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5E836DA-917D-295B-F627-F132594A1E8C}"/>
              </a:ext>
            </a:extLst>
          </p:cNvPr>
          <p:cNvSpPr/>
          <p:nvPr/>
        </p:nvSpPr>
        <p:spPr>
          <a:xfrm>
            <a:off x="7437119" y="5062387"/>
            <a:ext cx="3339593" cy="37446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36767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blue screen&#10;&#10;Description automatically generated">
            <a:extLst>
              <a:ext uri="{FF2B5EF4-FFF2-40B4-BE49-F238E27FC236}">
                <a16:creationId xmlns:a16="http://schemas.microsoft.com/office/drawing/2014/main" id="{251F7C32-9D8A-61FC-166A-E406FB2B8B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2156" y="45718"/>
            <a:ext cx="4042954" cy="211876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813E36A-3FCF-B6EA-80AA-302E812265C5}"/>
              </a:ext>
            </a:extLst>
          </p:cNvPr>
          <p:cNvSpPr txBox="1"/>
          <p:nvPr/>
        </p:nvSpPr>
        <p:spPr>
          <a:xfrm>
            <a:off x="128313" y="306977"/>
            <a:ext cx="11746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S11b</a:t>
            </a:r>
          </a:p>
        </p:txBody>
      </p:sp>
      <p:pic>
        <p:nvPicPr>
          <p:cNvPr id="6" name="Picture 5" descr="A close-up of a test&#10;&#10;Description automatically generated">
            <a:extLst>
              <a:ext uri="{FF2B5EF4-FFF2-40B4-BE49-F238E27FC236}">
                <a16:creationId xmlns:a16="http://schemas.microsoft.com/office/drawing/2014/main" id="{BE59FDE3-5677-2264-36EE-098969F107A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1" y="141517"/>
            <a:ext cx="4206240" cy="1440285"/>
          </a:xfrm>
          <a:prstGeom prst="rect">
            <a:avLst/>
          </a:prstGeom>
        </p:spPr>
      </p:pic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9B179430-A682-44FA-D2E8-B783AF24E0F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1" y="1640041"/>
            <a:ext cx="4206240" cy="1471251"/>
          </a:xfrm>
          <a:prstGeom prst="rect">
            <a:avLst/>
          </a:prstGeom>
        </p:spPr>
      </p:pic>
      <p:pic>
        <p:nvPicPr>
          <p:cNvPr id="10" name="Picture 9" descr="A close-up of a test&#10;&#10;Description automatically generated">
            <a:extLst>
              <a:ext uri="{FF2B5EF4-FFF2-40B4-BE49-F238E27FC236}">
                <a16:creationId xmlns:a16="http://schemas.microsoft.com/office/drawing/2014/main" id="{E36D2A68-7461-FFBB-CA91-51DD48113FC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2156" y="2185308"/>
            <a:ext cx="4042954" cy="1793414"/>
          </a:xfrm>
          <a:prstGeom prst="rect">
            <a:avLst/>
          </a:prstGeom>
        </p:spPr>
      </p:pic>
      <p:pic>
        <p:nvPicPr>
          <p:cNvPr id="12" name="Picture 11" descr="A close-up of a test&#10;&#10;Description automatically generated">
            <a:extLst>
              <a:ext uri="{FF2B5EF4-FFF2-40B4-BE49-F238E27FC236}">
                <a16:creationId xmlns:a16="http://schemas.microsoft.com/office/drawing/2014/main" id="{488E3620-EA1B-6F57-803B-FAAA1CD3D7A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2156" y="4012665"/>
            <a:ext cx="4042954" cy="1793414"/>
          </a:xfrm>
          <a:prstGeom prst="rect">
            <a:avLst/>
          </a:prstGeom>
        </p:spPr>
      </p:pic>
      <p:pic>
        <p:nvPicPr>
          <p:cNvPr id="14" name="Picture 13" descr="A close-up of a test&#10;&#10;Description automatically generated">
            <a:extLst>
              <a:ext uri="{FF2B5EF4-FFF2-40B4-BE49-F238E27FC236}">
                <a16:creationId xmlns:a16="http://schemas.microsoft.com/office/drawing/2014/main" id="{03FF75C3-08FB-AB55-0BB3-22FA14E6ADD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1" y="3142978"/>
            <a:ext cx="4206240" cy="1235988"/>
          </a:xfrm>
          <a:prstGeom prst="rect">
            <a:avLst/>
          </a:prstGeom>
        </p:spPr>
      </p:pic>
      <p:pic>
        <p:nvPicPr>
          <p:cNvPr id="16" name="Picture 15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BF8BB344-4291-2643-F520-28EADF338EF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2156" y="5815304"/>
            <a:ext cx="4042954" cy="1024215"/>
          </a:xfrm>
          <a:prstGeom prst="rect">
            <a:avLst/>
          </a:prstGeom>
        </p:spPr>
      </p:pic>
      <p:pic>
        <p:nvPicPr>
          <p:cNvPr id="18" name="Picture 17" descr="A close-up of a test&#10;&#10;Description automatically generated">
            <a:extLst>
              <a:ext uri="{FF2B5EF4-FFF2-40B4-BE49-F238E27FC236}">
                <a16:creationId xmlns:a16="http://schemas.microsoft.com/office/drawing/2014/main" id="{EFD547CE-3525-85EF-C7D9-2E36426AEFC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1" y="4456934"/>
            <a:ext cx="4206240" cy="2161878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id="{9435E2C1-1EA0-315E-9DE1-F79A11B68535}"/>
              </a:ext>
            </a:extLst>
          </p:cNvPr>
          <p:cNvSpPr/>
          <p:nvPr/>
        </p:nvSpPr>
        <p:spPr>
          <a:xfrm>
            <a:off x="1822972" y="645531"/>
            <a:ext cx="2757737" cy="2949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9BB744EB-161B-B8AA-B7DD-255B3865E98B}"/>
              </a:ext>
            </a:extLst>
          </p:cNvPr>
          <p:cNvSpPr/>
          <p:nvPr/>
        </p:nvSpPr>
        <p:spPr>
          <a:xfrm>
            <a:off x="1992788" y="3342465"/>
            <a:ext cx="2757737" cy="2949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369E8C7-601C-26CD-9317-E2402D616F1E}"/>
              </a:ext>
            </a:extLst>
          </p:cNvPr>
          <p:cNvSpPr/>
          <p:nvPr/>
        </p:nvSpPr>
        <p:spPr>
          <a:xfrm>
            <a:off x="1966660" y="4988381"/>
            <a:ext cx="2757737" cy="2949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80516AC-28FE-31A8-F4CC-7E6CD069376E}"/>
              </a:ext>
            </a:extLst>
          </p:cNvPr>
          <p:cNvSpPr/>
          <p:nvPr/>
        </p:nvSpPr>
        <p:spPr>
          <a:xfrm>
            <a:off x="1966659" y="6206040"/>
            <a:ext cx="2757737" cy="2949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2A633407-822D-E5A9-4BAC-551FA37E6F59}"/>
              </a:ext>
            </a:extLst>
          </p:cNvPr>
          <p:cNvSpPr/>
          <p:nvPr/>
        </p:nvSpPr>
        <p:spPr>
          <a:xfrm>
            <a:off x="6717188" y="688034"/>
            <a:ext cx="2836115" cy="2949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457AE923-8146-F3F8-B32F-8AA9A23636C9}"/>
              </a:ext>
            </a:extLst>
          </p:cNvPr>
          <p:cNvSpPr/>
          <p:nvPr/>
        </p:nvSpPr>
        <p:spPr>
          <a:xfrm>
            <a:off x="6499474" y="2484670"/>
            <a:ext cx="3053829" cy="2949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8B936053-A922-F192-665D-974C25899284}"/>
              </a:ext>
            </a:extLst>
          </p:cNvPr>
          <p:cNvSpPr/>
          <p:nvPr/>
        </p:nvSpPr>
        <p:spPr>
          <a:xfrm>
            <a:off x="6499474" y="3672362"/>
            <a:ext cx="2836115" cy="2949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97CAD127-53BB-F70B-8AD2-53E34BF6F888}"/>
              </a:ext>
            </a:extLst>
          </p:cNvPr>
          <p:cNvSpPr/>
          <p:nvPr/>
        </p:nvSpPr>
        <p:spPr>
          <a:xfrm>
            <a:off x="6499474" y="5294812"/>
            <a:ext cx="2958035" cy="2949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2353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test results of a dna&#10;&#10;Description automatically generated with medium confidence">
            <a:extLst>
              <a:ext uri="{FF2B5EF4-FFF2-40B4-BE49-F238E27FC236}">
                <a16:creationId xmlns:a16="http://schemas.microsoft.com/office/drawing/2014/main" id="{F1DA8C21-D405-78E8-9A97-9A663517F38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2230" y="296799"/>
            <a:ext cx="3886200" cy="2368296"/>
          </a:xfrm>
          <a:prstGeom prst="rect">
            <a:avLst/>
          </a:prstGeom>
        </p:spPr>
      </p:pic>
      <p:pic>
        <p:nvPicPr>
          <p:cNvPr id="7" name="Picture 6" descr="A close-up of a test&#10;&#10;Description automatically generated">
            <a:extLst>
              <a:ext uri="{FF2B5EF4-FFF2-40B4-BE49-F238E27FC236}">
                <a16:creationId xmlns:a16="http://schemas.microsoft.com/office/drawing/2014/main" id="{644C137E-29A8-64D7-35AC-F93437E826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8620" y="4221490"/>
            <a:ext cx="3130296" cy="2298192"/>
          </a:xfrm>
          <a:prstGeom prst="rect">
            <a:avLst/>
          </a:prstGeom>
        </p:spPr>
      </p:pic>
      <p:pic>
        <p:nvPicPr>
          <p:cNvPr id="9" name="Picture 8" descr="A close-up of a test&#10;&#10;Description automatically generated">
            <a:extLst>
              <a:ext uri="{FF2B5EF4-FFF2-40B4-BE49-F238E27FC236}">
                <a16:creationId xmlns:a16="http://schemas.microsoft.com/office/drawing/2014/main" id="{12A16654-EEBE-14FE-1873-508444FCA46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6382" y="3010281"/>
            <a:ext cx="3130296" cy="321564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7952DEC-F72E-A676-06B9-FE19B4D549B8}"/>
              </a:ext>
            </a:extLst>
          </p:cNvPr>
          <p:cNvSpPr txBox="1"/>
          <p:nvPr/>
        </p:nvSpPr>
        <p:spPr>
          <a:xfrm>
            <a:off x="164309" y="296799"/>
            <a:ext cx="9485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2c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B6292C5-4B30-AFBC-80E0-430BAFDF62B7}"/>
              </a:ext>
            </a:extLst>
          </p:cNvPr>
          <p:cNvSpPr/>
          <p:nvPr/>
        </p:nvSpPr>
        <p:spPr>
          <a:xfrm>
            <a:off x="2582638" y="986255"/>
            <a:ext cx="1466850" cy="50291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62154FB-2C8A-3695-4819-EBE82FDF393A}"/>
              </a:ext>
            </a:extLst>
          </p:cNvPr>
          <p:cNvSpPr/>
          <p:nvPr/>
        </p:nvSpPr>
        <p:spPr>
          <a:xfrm>
            <a:off x="3214010" y="4221490"/>
            <a:ext cx="1466850" cy="50291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00ECDF1-35EF-29BB-11BC-B0F6EA0A6238}"/>
              </a:ext>
            </a:extLst>
          </p:cNvPr>
          <p:cNvSpPr/>
          <p:nvPr/>
        </p:nvSpPr>
        <p:spPr>
          <a:xfrm>
            <a:off x="3214010" y="3719818"/>
            <a:ext cx="1466850" cy="40874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80013AF-E631-D2B0-3135-C70A3969DCDD}"/>
              </a:ext>
            </a:extLst>
          </p:cNvPr>
          <p:cNvSpPr/>
          <p:nvPr/>
        </p:nvSpPr>
        <p:spPr>
          <a:xfrm>
            <a:off x="8495757" y="4943222"/>
            <a:ext cx="1466850" cy="40874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8" name="Picture 17" descr="A close-up of a test&#10;&#10;Description automatically generated">
            <a:extLst>
              <a:ext uri="{FF2B5EF4-FFF2-40B4-BE49-F238E27FC236}">
                <a16:creationId xmlns:a16="http://schemas.microsoft.com/office/drawing/2014/main" id="{2D438462-AA1E-AA7A-CD6E-8E2C6BAACE4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7086" y="296799"/>
            <a:ext cx="5766816" cy="3767328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B3DA333A-A0D0-17EF-F209-4ACBECC8E957}"/>
              </a:ext>
            </a:extLst>
          </p:cNvPr>
          <p:cNvSpPr/>
          <p:nvPr/>
        </p:nvSpPr>
        <p:spPr>
          <a:xfrm>
            <a:off x="7230675" y="2531328"/>
            <a:ext cx="1466850" cy="50291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A819A8AA-FD39-4073-38BF-C1B2BDCBC73A}"/>
              </a:ext>
            </a:extLst>
          </p:cNvPr>
          <p:cNvSpPr/>
          <p:nvPr/>
        </p:nvSpPr>
        <p:spPr>
          <a:xfrm>
            <a:off x="7230675" y="2015333"/>
            <a:ext cx="1466850" cy="40874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1A2A5494-09C4-0D73-3769-1804A3AF6669}"/>
              </a:ext>
            </a:extLst>
          </p:cNvPr>
          <p:cNvSpPr/>
          <p:nvPr/>
        </p:nvSpPr>
        <p:spPr>
          <a:xfrm>
            <a:off x="9012066" y="1991374"/>
            <a:ext cx="1466850" cy="40874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5852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7D91523-979F-792D-6C15-B0BDD5C77F56}"/>
              </a:ext>
            </a:extLst>
          </p:cNvPr>
          <p:cNvSpPr txBox="1"/>
          <p:nvPr/>
        </p:nvSpPr>
        <p:spPr>
          <a:xfrm>
            <a:off x="173083" y="308066"/>
            <a:ext cx="9598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2g</a:t>
            </a:r>
          </a:p>
        </p:txBody>
      </p:sp>
      <p:pic>
        <p:nvPicPr>
          <p:cNvPr id="4" name="Picture 3" descr="A close-up of a paper&#10;&#10;Description automatically generated">
            <a:extLst>
              <a:ext uri="{FF2B5EF4-FFF2-40B4-BE49-F238E27FC236}">
                <a16:creationId xmlns:a16="http://schemas.microsoft.com/office/drawing/2014/main" id="{19CDFF41-96CC-D717-2547-C7D13377AF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5042" y="200297"/>
            <a:ext cx="4571595" cy="1845460"/>
          </a:xfrm>
          <a:prstGeom prst="rect">
            <a:avLst/>
          </a:prstGeom>
        </p:spPr>
      </p:pic>
      <p:pic>
        <p:nvPicPr>
          <p:cNvPr id="6" name="Picture 5" descr="A close-up of a test results&#10;&#10;Description automatically generated">
            <a:extLst>
              <a:ext uri="{FF2B5EF4-FFF2-40B4-BE49-F238E27FC236}">
                <a16:creationId xmlns:a16="http://schemas.microsoft.com/office/drawing/2014/main" id="{8B3DC7A3-4BDD-F256-936C-05C14A8AE5B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0213" y="200297"/>
            <a:ext cx="4417305" cy="2970485"/>
          </a:xfrm>
          <a:prstGeom prst="rect">
            <a:avLst/>
          </a:prstGeom>
        </p:spPr>
      </p:pic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AB63A875-4678-CE59-5339-D5B98D56A03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4721" y="2282291"/>
            <a:ext cx="4732239" cy="4450742"/>
          </a:xfrm>
          <a:prstGeom prst="rect">
            <a:avLst/>
          </a:prstGeom>
        </p:spPr>
      </p:pic>
      <p:pic>
        <p:nvPicPr>
          <p:cNvPr id="10" name="Picture 9" descr="A close-up of a test&#10;&#10;Description automatically generated">
            <a:extLst>
              <a:ext uri="{FF2B5EF4-FFF2-40B4-BE49-F238E27FC236}">
                <a16:creationId xmlns:a16="http://schemas.microsoft.com/office/drawing/2014/main" id="{021FC492-68A0-18FE-97BA-8ADF9E6B48A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9658" y="3335842"/>
            <a:ext cx="4824330" cy="3078666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EBD3C77A-5EEC-C1B7-C71C-D61B012D9682}"/>
              </a:ext>
            </a:extLst>
          </p:cNvPr>
          <p:cNvSpPr/>
          <p:nvPr/>
        </p:nvSpPr>
        <p:spPr>
          <a:xfrm>
            <a:off x="2323988" y="923465"/>
            <a:ext cx="2674731" cy="39912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63F9F33-3ADA-704F-FD18-1D3CE070F1CE}"/>
              </a:ext>
            </a:extLst>
          </p:cNvPr>
          <p:cNvSpPr/>
          <p:nvPr/>
        </p:nvSpPr>
        <p:spPr>
          <a:xfrm>
            <a:off x="2154171" y="3906151"/>
            <a:ext cx="2674731" cy="39912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6AD0983-D46E-AD70-BD0C-3851458A0433}"/>
              </a:ext>
            </a:extLst>
          </p:cNvPr>
          <p:cNvSpPr/>
          <p:nvPr/>
        </p:nvSpPr>
        <p:spPr>
          <a:xfrm>
            <a:off x="2049668" y="4875175"/>
            <a:ext cx="2674731" cy="39912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3856DF5-0F46-3DCE-96D8-2D4E7CC0F34D}"/>
              </a:ext>
            </a:extLst>
          </p:cNvPr>
          <p:cNvSpPr/>
          <p:nvPr/>
        </p:nvSpPr>
        <p:spPr>
          <a:xfrm>
            <a:off x="8151224" y="988779"/>
            <a:ext cx="2865120" cy="39912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F6DFB39-A4B3-C7E9-E7D5-0314690D1F76}"/>
              </a:ext>
            </a:extLst>
          </p:cNvPr>
          <p:cNvSpPr/>
          <p:nvPr/>
        </p:nvSpPr>
        <p:spPr>
          <a:xfrm>
            <a:off x="8024457" y="3973545"/>
            <a:ext cx="2887383" cy="4417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3980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test&#10;&#10;Description automatically generated">
            <a:extLst>
              <a:ext uri="{FF2B5EF4-FFF2-40B4-BE49-F238E27FC236}">
                <a16:creationId xmlns:a16="http://schemas.microsoft.com/office/drawing/2014/main" id="{D4893D61-6578-63FE-43B8-7177A431C3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8949" y="152013"/>
            <a:ext cx="4382589" cy="3159594"/>
          </a:xfrm>
          <a:prstGeom prst="rect">
            <a:avLst/>
          </a:prstGeom>
        </p:spPr>
      </p:pic>
      <p:pic>
        <p:nvPicPr>
          <p:cNvPr id="5" name="Picture 4" descr="A close-up of a test&#10;&#10;Description automatically generated">
            <a:extLst>
              <a:ext uri="{FF2B5EF4-FFF2-40B4-BE49-F238E27FC236}">
                <a16:creationId xmlns:a16="http://schemas.microsoft.com/office/drawing/2014/main" id="{CE1FF7DD-4CA2-E003-B7DC-86B807BC6FA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7590" y="128669"/>
            <a:ext cx="5190309" cy="2208863"/>
          </a:xfrm>
          <a:prstGeom prst="rect">
            <a:avLst/>
          </a:prstGeom>
        </p:spPr>
      </p:pic>
      <p:pic>
        <p:nvPicPr>
          <p:cNvPr id="7" name="Picture 6" descr="A screen shot of a test&#10;&#10;Description automatically generated">
            <a:extLst>
              <a:ext uri="{FF2B5EF4-FFF2-40B4-BE49-F238E27FC236}">
                <a16:creationId xmlns:a16="http://schemas.microsoft.com/office/drawing/2014/main" id="{69AFC5A6-7830-276E-1E8C-03A3A29E419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8949" y="3570342"/>
            <a:ext cx="4574177" cy="1528099"/>
          </a:xfrm>
          <a:prstGeom prst="rect">
            <a:avLst/>
          </a:prstGeom>
        </p:spPr>
      </p:pic>
      <p:pic>
        <p:nvPicPr>
          <p:cNvPr id="9" name="Picture 8" descr="A close-up of a test&#10;&#10;Description automatically generated">
            <a:extLst>
              <a:ext uri="{FF2B5EF4-FFF2-40B4-BE49-F238E27FC236}">
                <a16:creationId xmlns:a16="http://schemas.microsoft.com/office/drawing/2014/main" id="{946EC7F7-2482-DC4C-A46F-3404DCA601B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4804" y="2618885"/>
            <a:ext cx="5135880" cy="360578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0A01FE1-852B-36E0-7CED-0C86BBB1F656}"/>
              </a:ext>
            </a:extLst>
          </p:cNvPr>
          <p:cNvSpPr txBox="1"/>
          <p:nvPr/>
        </p:nvSpPr>
        <p:spPr>
          <a:xfrm>
            <a:off x="173083" y="308066"/>
            <a:ext cx="9598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2g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A001A11-C432-CB7E-4D8A-AAB895DD10D6}"/>
              </a:ext>
            </a:extLst>
          </p:cNvPr>
          <p:cNvSpPr/>
          <p:nvPr/>
        </p:nvSpPr>
        <p:spPr>
          <a:xfrm>
            <a:off x="2323988" y="1731810"/>
            <a:ext cx="2613772" cy="39912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6D9ED12-A211-0DF8-54F2-3B59524DF50B}"/>
              </a:ext>
            </a:extLst>
          </p:cNvPr>
          <p:cNvSpPr/>
          <p:nvPr/>
        </p:nvSpPr>
        <p:spPr>
          <a:xfrm>
            <a:off x="2323988" y="1010555"/>
            <a:ext cx="2674731" cy="39912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7C960823-7F6F-FFAD-279F-4D5212D961A3}"/>
              </a:ext>
            </a:extLst>
          </p:cNvPr>
          <p:cNvSpPr/>
          <p:nvPr/>
        </p:nvSpPr>
        <p:spPr>
          <a:xfrm>
            <a:off x="2682239" y="4087198"/>
            <a:ext cx="2516777" cy="39912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BCD4159-D317-9ED0-8A48-0E7AD5A6E63E}"/>
              </a:ext>
            </a:extLst>
          </p:cNvPr>
          <p:cNvSpPr/>
          <p:nvPr/>
        </p:nvSpPr>
        <p:spPr>
          <a:xfrm>
            <a:off x="7435919" y="1033538"/>
            <a:ext cx="2796652" cy="39912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6FAF378-E996-C41F-FF56-D2CD24B11931}"/>
              </a:ext>
            </a:extLst>
          </p:cNvPr>
          <p:cNvSpPr/>
          <p:nvPr/>
        </p:nvSpPr>
        <p:spPr>
          <a:xfrm>
            <a:off x="7662342" y="4807488"/>
            <a:ext cx="3084035" cy="39912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1572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5CF5A67-1CD5-E0A6-5E7E-97054C977451}"/>
              </a:ext>
            </a:extLst>
          </p:cNvPr>
          <p:cNvSpPr txBox="1"/>
          <p:nvPr/>
        </p:nvSpPr>
        <p:spPr>
          <a:xfrm>
            <a:off x="173083" y="308066"/>
            <a:ext cx="9726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3d</a:t>
            </a:r>
          </a:p>
        </p:txBody>
      </p:sp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7E7E9C6E-02DC-2C9F-0993-31D273B06A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419" y="2040282"/>
            <a:ext cx="5783581" cy="2129531"/>
          </a:xfrm>
          <a:prstGeom prst="rect">
            <a:avLst/>
          </a:prstGeom>
        </p:spPr>
      </p:pic>
      <p:pic>
        <p:nvPicPr>
          <p:cNvPr id="6" name="Picture 5" descr="A close-up of a test&#10;&#10;Description automatically generated">
            <a:extLst>
              <a:ext uri="{FF2B5EF4-FFF2-40B4-BE49-F238E27FC236}">
                <a16:creationId xmlns:a16="http://schemas.microsoft.com/office/drawing/2014/main" id="{56DEE4E2-5D6B-F81B-3702-0780A7FD349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5589" y="3105048"/>
            <a:ext cx="5613328" cy="2760830"/>
          </a:xfrm>
          <a:prstGeom prst="rect">
            <a:avLst/>
          </a:prstGeom>
        </p:spPr>
      </p:pic>
      <p:pic>
        <p:nvPicPr>
          <p:cNvPr id="8" name="Picture 7" descr="A diagram of a graph&#10;&#10;Description automatically generated with medium confidence">
            <a:extLst>
              <a:ext uri="{FF2B5EF4-FFF2-40B4-BE49-F238E27FC236}">
                <a16:creationId xmlns:a16="http://schemas.microsoft.com/office/drawing/2014/main" id="{9D5BB583-D12E-2624-37BF-4B4F2EBF352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5589" y="124968"/>
            <a:ext cx="5613328" cy="2760830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B20B7168-9808-6B8E-1A42-A43472A8B312}"/>
              </a:ext>
            </a:extLst>
          </p:cNvPr>
          <p:cNvSpPr/>
          <p:nvPr/>
        </p:nvSpPr>
        <p:spPr>
          <a:xfrm>
            <a:off x="7366251" y="992122"/>
            <a:ext cx="3345292" cy="4535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22B5767-9196-025E-75C6-9E66BFF23617}"/>
              </a:ext>
            </a:extLst>
          </p:cNvPr>
          <p:cNvSpPr/>
          <p:nvPr/>
        </p:nvSpPr>
        <p:spPr>
          <a:xfrm>
            <a:off x="7366250" y="3848751"/>
            <a:ext cx="3458503" cy="34718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CB37FB4-B220-15B9-4153-E4A2BA95B086}"/>
              </a:ext>
            </a:extLst>
          </p:cNvPr>
          <p:cNvSpPr/>
          <p:nvPr/>
        </p:nvSpPr>
        <p:spPr>
          <a:xfrm>
            <a:off x="1457484" y="2729482"/>
            <a:ext cx="3445441" cy="4535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0213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C52BF80-E9FD-1C7E-8068-5CB1B4BBFE98}"/>
              </a:ext>
            </a:extLst>
          </p:cNvPr>
          <p:cNvSpPr txBox="1"/>
          <p:nvPr/>
        </p:nvSpPr>
        <p:spPr>
          <a:xfrm>
            <a:off x="121595" y="383962"/>
            <a:ext cx="9726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4h</a:t>
            </a:r>
          </a:p>
        </p:txBody>
      </p:sp>
      <p:pic>
        <p:nvPicPr>
          <p:cNvPr id="4" name="Picture 3" descr="A close-up of a blue screen&#10;&#10;Description automatically generated">
            <a:extLst>
              <a:ext uri="{FF2B5EF4-FFF2-40B4-BE49-F238E27FC236}">
                <a16:creationId xmlns:a16="http://schemas.microsoft.com/office/drawing/2014/main" id="{5287282E-581A-9E44-1E42-260A761D32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234" y="308066"/>
            <a:ext cx="5254317" cy="1559639"/>
          </a:xfrm>
          <a:prstGeom prst="rect">
            <a:avLst/>
          </a:prstGeom>
        </p:spPr>
      </p:pic>
      <p:pic>
        <p:nvPicPr>
          <p:cNvPr id="6" name="Picture 5" descr="A close-up of a test&#10;&#10;Description automatically generated">
            <a:extLst>
              <a:ext uri="{FF2B5EF4-FFF2-40B4-BE49-F238E27FC236}">
                <a16:creationId xmlns:a16="http://schemas.microsoft.com/office/drawing/2014/main" id="{69B7F8E5-70D7-DFB6-C414-E563790953E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234" y="2232442"/>
            <a:ext cx="5254317" cy="1837244"/>
          </a:xfrm>
          <a:prstGeom prst="rect">
            <a:avLst/>
          </a:prstGeom>
        </p:spPr>
      </p:pic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217B5EB0-7E85-C40F-E4C6-4CC58D09C31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234" y="4236720"/>
            <a:ext cx="5254317" cy="2231875"/>
          </a:xfrm>
          <a:prstGeom prst="rect">
            <a:avLst/>
          </a:prstGeom>
        </p:spPr>
      </p:pic>
      <p:pic>
        <p:nvPicPr>
          <p:cNvPr id="10" name="Picture 9" descr="A blue paper with writing on it&#10;&#10;Description automatically generated">
            <a:extLst>
              <a:ext uri="{FF2B5EF4-FFF2-40B4-BE49-F238E27FC236}">
                <a16:creationId xmlns:a16="http://schemas.microsoft.com/office/drawing/2014/main" id="{9CFDF818-6BD0-3456-57DB-A853CE17BA5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8509" y="308066"/>
            <a:ext cx="5390408" cy="1433648"/>
          </a:xfrm>
          <a:prstGeom prst="rect">
            <a:avLst/>
          </a:prstGeom>
        </p:spPr>
      </p:pic>
      <p:pic>
        <p:nvPicPr>
          <p:cNvPr id="12" name="Picture 11" descr="A close-up of a test&#10;&#10;Description automatically generated">
            <a:extLst>
              <a:ext uri="{FF2B5EF4-FFF2-40B4-BE49-F238E27FC236}">
                <a16:creationId xmlns:a16="http://schemas.microsoft.com/office/drawing/2014/main" id="{95D6679B-824E-253E-1739-09841AC47F2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28509" y="1867705"/>
            <a:ext cx="5406235" cy="3731906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1291D012-4F8E-9FA5-021D-1EE1BF2B5EB6}"/>
              </a:ext>
            </a:extLst>
          </p:cNvPr>
          <p:cNvSpPr/>
          <p:nvPr/>
        </p:nvSpPr>
        <p:spPr>
          <a:xfrm>
            <a:off x="1762284" y="961643"/>
            <a:ext cx="3445441" cy="34464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F8A68963-492B-EC96-8507-A1375AD04F59}"/>
              </a:ext>
            </a:extLst>
          </p:cNvPr>
          <p:cNvSpPr/>
          <p:nvPr/>
        </p:nvSpPr>
        <p:spPr>
          <a:xfrm>
            <a:off x="1923392" y="3256678"/>
            <a:ext cx="3445441" cy="34464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4C5B258F-3A80-C80E-EA01-65F9C5BD3C72}"/>
              </a:ext>
            </a:extLst>
          </p:cNvPr>
          <p:cNvSpPr/>
          <p:nvPr/>
        </p:nvSpPr>
        <p:spPr>
          <a:xfrm>
            <a:off x="1636010" y="4921599"/>
            <a:ext cx="3658801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604469B-D168-D2F9-6DA9-6906A4987C8B}"/>
              </a:ext>
            </a:extLst>
          </p:cNvPr>
          <p:cNvSpPr/>
          <p:nvPr/>
        </p:nvSpPr>
        <p:spPr>
          <a:xfrm>
            <a:off x="7430256" y="1153881"/>
            <a:ext cx="3658801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871DFCDA-E103-F99C-97AE-5DCAD37001B9}"/>
              </a:ext>
            </a:extLst>
          </p:cNvPr>
          <p:cNvSpPr/>
          <p:nvPr/>
        </p:nvSpPr>
        <p:spPr>
          <a:xfrm>
            <a:off x="7239976" y="2613062"/>
            <a:ext cx="3658801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1BAFF3C-A11C-CB45-0B87-0A5019C2CE44}"/>
              </a:ext>
            </a:extLst>
          </p:cNvPr>
          <p:cNvSpPr/>
          <p:nvPr/>
        </p:nvSpPr>
        <p:spPr>
          <a:xfrm>
            <a:off x="7177709" y="3316312"/>
            <a:ext cx="3658801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6361E5EC-3AFC-B25D-6E6D-646E6FD5B488}"/>
              </a:ext>
            </a:extLst>
          </p:cNvPr>
          <p:cNvSpPr/>
          <p:nvPr/>
        </p:nvSpPr>
        <p:spPr>
          <a:xfrm>
            <a:off x="7177708" y="3993435"/>
            <a:ext cx="3658801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4007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-up of a dna test&#10;&#10;Description automatically generated">
            <a:extLst>
              <a:ext uri="{FF2B5EF4-FFF2-40B4-BE49-F238E27FC236}">
                <a16:creationId xmlns:a16="http://schemas.microsoft.com/office/drawing/2014/main" id="{1A24B6F0-57B2-BB9F-FB76-B3D87421D7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2611" y="1153886"/>
            <a:ext cx="5254317" cy="3396500"/>
          </a:xfrm>
          <a:prstGeom prst="rect">
            <a:avLst/>
          </a:prstGeom>
        </p:spPr>
      </p:pic>
      <p:pic>
        <p:nvPicPr>
          <p:cNvPr id="3" name="Picture 2" descr="A close-up of a test&#10;&#10;Description automatically generated">
            <a:extLst>
              <a:ext uri="{FF2B5EF4-FFF2-40B4-BE49-F238E27FC236}">
                <a16:creationId xmlns:a16="http://schemas.microsoft.com/office/drawing/2014/main" id="{75F4C231-FD0B-07CE-E439-25EF4B4B5C3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3929" y="1153886"/>
            <a:ext cx="5392609" cy="278696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835348E-4713-7A33-D9A1-27CA34AED14C}"/>
              </a:ext>
            </a:extLst>
          </p:cNvPr>
          <p:cNvSpPr txBox="1"/>
          <p:nvPr/>
        </p:nvSpPr>
        <p:spPr>
          <a:xfrm>
            <a:off x="121595" y="383962"/>
            <a:ext cx="9726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4h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A8A5B6E8-0242-CDDA-C921-10911CE771E9}"/>
              </a:ext>
            </a:extLst>
          </p:cNvPr>
          <p:cNvSpPr/>
          <p:nvPr/>
        </p:nvSpPr>
        <p:spPr>
          <a:xfrm>
            <a:off x="1810181" y="1951976"/>
            <a:ext cx="3658801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F8AA31CF-10B6-BE8D-BC80-75E6E65A8500}"/>
              </a:ext>
            </a:extLst>
          </p:cNvPr>
          <p:cNvSpPr/>
          <p:nvPr/>
        </p:nvSpPr>
        <p:spPr>
          <a:xfrm>
            <a:off x="7157244" y="2169061"/>
            <a:ext cx="3862145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2393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1E05F1D-FDFE-F4A6-792D-30D2A307FDB8}"/>
              </a:ext>
            </a:extLst>
          </p:cNvPr>
          <p:cNvSpPr txBox="1"/>
          <p:nvPr/>
        </p:nvSpPr>
        <p:spPr>
          <a:xfrm>
            <a:off x="121595" y="383962"/>
            <a:ext cx="9726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5d</a:t>
            </a:r>
          </a:p>
        </p:txBody>
      </p:sp>
      <p:pic>
        <p:nvPicPr>
          <p:cNvPr id="4" name="Picture 3" descr="A close-up of a test&#10;&#10;Description automatically generated">
            <a:extLst>
              <a:ext uri="{FF2B5EF4-FFF2-40B4-BE49-F238E27FC236}">
                <a16:creationId xmlns:a16="http://schemas.microsoft.com/office/drawing/2014/main" id="{FAEFA1AC-258F-EEC2-8455-B876B28F9AC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6494" y="60112"/>
            <a:ext cx="5354900" cy="2001855"/>
          </a:xfrm>
          <a:prstGeom prst="rect">
            <a:avLst/>
          </a:prstGeom>
        </p:spPr>
      </p:pic>
      <p:pic>
        <p:nvPicPr>
          <p:cNvPr id="6" name="Picture 5" descr="A close-up of a test&#10;&#10;Description automatically generated">
            <a:extLst>
              <a:ext uri="{FF2B5EF4-FFF2-40B4-BE49-F238E27FC236}">
                <a16:creationId xmlns:a16="http://schemas.microsoft.com/office/drawing/2014/main" id="{D1753560-EC27-C52B-EE63-B814F375717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10291" y="117263"/>
            <a:ext cx="4511150" cy="2637758"/>
          </a:xfrm>
          <a:prstGeom prst="rect">
            <a:avLst/>
          </a:prstGeom>
        </p:spPr>
      </p:pic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674BA317-038F-5132-0F05-06FD92328F7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5074" y="2101487"/>
            <a:ext cx="4511150" cy="2723923"/>
          </a:xfrm>
          <a:prstGeom prst="rect">
            <a:avLst/>
          </a:prstGeom>
        </p:spPr>
      </p:pic>
      <p:pic>
        <p:nvPicPr>
          <p:cNvPr id="10" name="Picture 9" descr="A close-up of a test paper&#10;&#10;Description automatically generated">
            <a:extLst>
              <a:ext uri="{FF2B5EF4-FFF2-40B4-BE49-F238E27FC236}">
                <a16:creationId xmlns:a16="http://schemas.microsoft.com/office/drawing/2014/main" id="{505D5F29-67A2-8DD7-9B04-31586B79967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10290" y="2837307"/>
            <a:ext cx="4511151" cy="2243068"/>
          </a:xfrm>
          <a:prstGeom prst="rect">
            <a:avLst/>
          </a:prstGeom>
        </p:spPr>
      </p:pic>
      <p:pic>
        <p:nvPicPr>
          <p:cNvPr id="12" name="Picture 11" descr="A close-up of a test&#10;&#10;Description automatically generated">
            <a:extLst>
              <a:ext uri="{FF2B5EF4-FFF2-40B4-BE49-F238E27FC236}">
                <a16:creationId xmlns:a16="http://schemas.microsoft.com/office/drawing/2014/main" id="{50269666-4E53-8A61-41C3-3D9DB752EFA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705"/>
          <a:stretch/>
        </p:blipFill>
        <p:spPr>
          <a:xfrm>
            <a:off x="1448778" y="4864931"/>
            <a:ext cx="4799622" cy="1954970"/>
          </a:xfrm>
          <a:prstGeom prst="rect">
            <a:avLst/>
          </a:prstGeom>
        </p:spPr>
      </p:pic>
      <p:pic>
        <p:nvPicPr>
          <p:cNvPr id="14" name="Picture 13" descr="A close-up of a whiteboard&#10;&#10;Description automatically generated">
            <a:extLst>
              <a:ext uri="{FF2B5EF4-FFF2-40B4-BE49-F238E27FC236}">
                <a16:creationId xmlns:a16="http://schemas.microsoft.com/office/drawing/2014/main" id="{FFFFFAB5-A1B8-1CE0-6248-9B54D0D24F6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10290" y="5162661"/>
            <a:ext cx="4511150" cy="1560969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B445C82C-1BAF-DA75-75F9-62B5A32050AF}"/>
              </a:ext>
            </a:extLst>
          </p:cNvPr>
          <p:cNvSpPr/>
          <p:nvPr/>
        </p:nvSpPr>
        <p:spPr>
          <a:xfrm>
            <a:off x="2570549" y="515139"/>
            <a:ext cx="2592001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41003BAF-AE53-48D3-EE65-D757AC29F9AA}"/>
              </a:ext>
            </a:extLst>
          </p:cNvPr>
          <p:cNvSpPr/>
          <p:nvPr/>
        </p:nvSpPr>
        <p:spPr>
          <a:xfrm>
            <a:off x="2570549" y="1187251"/>
            <a:ext cx="2592001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FBFF85C-D612-A7BF-CDCF-A7672C5CD9C4}"/>
              </a:ext>
            </a:extLst>
          </p:cNvPr>
          <p:cNvSpPr/>
          <p:nvPr/>
        </p:nvSpPr>
        <p:spPr>
          <a:xfrm>
            <a:off x="2389574" y="3211914"/>
            <a:ext cx="2772976" cy="34091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53D4801-F5F9-1B0E-C23E-2988CBB02059}"/>
              </a:ext>
            </a:extLst>
          </p:cNvPr>
          <p:cNvSpPr/>
          <p:nvPr/>
        </p:nvSpPr>
        <p:spPr>
          <a:xfrm>
            <a:off x="2284799" y="5408245"/>
            <a:ext cx="2877751" cy="44963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E4DA643-941B-E20F-23A7-E35FA645BF16}"/>
              </a:ext>
            </a:extLst>
          </p:cNvPr>
          <p:cNvSpPr/>
          <p:nvPr/>
        </p:nvSpPr>
        <p:spPr>
          <a:xfrm>
            <a:off x="2284799" y="6318823"/>
            <a:ext cx="2877751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7D8BAF3-62D4-C95E-0A82-71A132C6EB8C}"/>
              </a:ext>
            </a:extLst>
          </p:cNvPr>
          <p:cNvSpPr/>
          <p:nvPr/>
        </p:nvSpPr>
        <p:spPr>
          <a:xfrm>
            <a:off x="7969864" y="753869"/>
            <a:ext cx="2775642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483E742-26D8-A176-9A09-6417A1309CA8}"/>
              </a:ext>
            </a:extLst>
          </p:cNvPr>
          <p:cNvSpPr/>
          <p:nvPr/>
        </p:nvSpPr>
        <p:spPr>
          <a:xfrm>
            <a:off x="7895024" y="5943145"/>
            <a:ext cx="2706301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1FC4133-3CA9-C086-E20F-76AD519CEC31}"/>
              </a:ext>
            </a:extLst>
          </p:cNvPr>
          <p:cNvSpPr/>
          <p:nvPr/>
        </p:nvSpPr>
        <p:spPr>
          <a:xfrm>
            <a:off x="7952173" y="3515934"/>
            <a:ext cx="2793333" cy="43417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3954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6414789-63A6-B2FB-A0AC-FF25932D03F2}"/>
              </a:ext>
            </a:extLst>
          </p:cNvPr>
          <p:cNvSpPr txBox="1"/>
          <p:nvPr/>
        </p:nvSpPr>
        <p:spPr>
          <a:xfrm>
            <a:off x="121595" y="383962"/>
            <a:ext cx="9726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igure 6b</a:t>
            </a:r>
          </a:p>
        </p:txBody>
      </p:sp>
      <p:pic>
        <p:nvPicPr>
          <p:cNvPr id="4" name="Picture 3" descr="A close-up of several black lines&#10;&#10;Description automatically generated">
            <a:extLst>
              <a:ext uri="{FF2B5EF4-FFF2-40B4-BE49-F238E27FC236}">
                <a16:creationId xmlns:a16="http://schemas.microsoft.com/office/drawing/2014/main" id="{3B132861-D2BA-7292-6630-5FF97F6DAD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235" y="65967"/>
            <a:ext cx="4540212" cy="2715706"/>
          </a:xfrm>
          <a:prstGeom prst="rect">
            <a:avLst/>
          </a:prstGeom>
        </p:spPr>
      </p:pic>
      <p:pic>
        <p:nvPicPr>
          <p:cNvPr id="6" name="Picture 5" descr="A close up of a line&#10;&#10;Description automatically generated">
            <a:extLst>
              <a:ext uri="{FF2B5EF4-FFF2-40B4-BE49-F238E27FC236}">
                <a16:creationId xmlns:a16="http://schemas.microsoft.com/office/drawing/2014/main" id="{BE49FCB2-6B21-9E3B-7E95-3DAD8E78D73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235" y="2864622"/>
            <a:ext cx="4540212" cy="1216337"/>
          </a:xfrm>
          <a:prstGeom prst="rect">
            <a:avLst/>
          </a:prstGeom>
        </p:spPr>
      </p:pic>
      <p:pic>
        <p:nvPicPr>
          <p:cNvPr id="8" name="Picture 7" descr="A close up of a line&#10;&#10;Description automatically generated">
            <a:extLst>
              <a:ext uri="{FF2B5EF4-FFF2-40B4-BE49-F238E27FC236}">
                <a16:creationId xmlns:a16="http://schemas.microsoft.com/office/drawing/2014/main" id="{60863B87-0CF1-7C33-A6D4-502590658DD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235" y="4139140"/>
            <a:ext cx="4540212" cy="1216337"/>
          </a:xfrm>
          <a:prstGeom prst="rect">
            <a:avLst/>
          </a:prstGeom>
        </p:spPr>
      </p:pic>
      <p:pic>
        <p:nvPicPr>
          <p:cNvPr id="10" name="Picture 9" descr="A close-up of a test&#10;&#10;Description automatically generated">
            <a:extLst>
              <a:ext uri="{FF2B5EF4-FFF2-40B4-BE49-F238E27FC236}">
                <a16:creationId xmlns:a16="http://schemas.microsoft.com/office/drawing/2014/main" id="{550514F3-5DE5-CA81-9667-353F83B6DD3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3468" y="74676"/>
            <a:ext cx="4426784" cy="2374179"/>
          </a:xfrm>
          <a:prstGeom prst="rect">
            <a:avLst/>
          </a:prstGeom>
        </p:spPr>
      </p:pic>
      <p:pic>
        <p:nvPicPr>
          <p:cNvPr id="12" name="Picture 11" descr="A close-up of a test&#10;&#10;Description automatically generated">
            <a:extLst>
              <a:ext uri="{FF2B5EF4-FFF2-40B4-BE49-F238E27FC236}">
                <a16:creationId xmlns:a16="http://schemas.microsoft.com/office/drawing/2014/main" id="{1C325DF2-F6E5-0316-738B-300189B32A2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1669" y="2617738"/>
            <a:ext cx="4822502" cy="1885369"/>
          </a:xfrm>
          <a:prstGeom prst="rect">
            <a:avLst/>
          </a:prstGeom>
        </p:spPr>
      </p:pic>
      <p:pic>
        <p:nvPicPr>
          <p:cNvPr id="14" name="Picture 13" descr="A close up of a line&#10;&#10;Description automatically generated">
            <a:extLst>
              <a:ext uri="{FF2B5EF4-FFF2-40B4-BE49-F238E27FC236}">
                <a16:creationId xmlns:a16="http://schemas.microsoft.com/office/drawing/2014/main" id="{381F4C31-8D63-6A19-4AB0-2663E270CF5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4235" y="5458885"/>
            <a:ext cx="4540212" cy="1308120"/>
          </a:xfrm>
          <a:prstGeom prst="rect">
            <a:avLst/>
          </a:prstGeom>
        </p:spPr>
      </p:pic>
      <p:pic>
        <p:nvPicPr>
          <p:cNvPr id="16" name="Picture 15" descr="A close-up of a test&#10;&#10;Description automatically generated">
            <a:extLst>
              <a:ext uri="{FF2B5EF4-FFF2-40B4-BE49-F238E27FC236}">
                <a16:creationId xmlns:a16="http://schemas.microsoft.com/office/drawing/2014/main" id="{87EE5A4C-C447-AEB8-33F9-0A9B29BBB8E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1669" y="4671991"/>
            <a:ext cx="4822502" cy="2111333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0C9070F2-B77B-78F4-2E93-B0E41C96901A}"/>
              </a:ext>
            </a:extLst>
          </p:cNvPr>
          <p:cNvSpPr/>
          <p:nvPr/>
        </p:nvSpPr>
        <p:spPr>
          <a:xfrm>
            <a:off x="1926115" y="722516"/>
            <a:ext cx="3116148" cy="296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DBD8298E-F4C2-E323-EA7F-1913B15D1362}"/>
              </a:ext>
            </a:extLst>
          </p:cNvPr>
          <p:cNvSpPr/>
          <p:nvPr/>
        </p:nvSpPr>
        <p:spPr>
          <a:xfrm>
            <a:off x="1926115" y="1018901"/>
            <a:ext cx="3116148" cy="296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5161BBDC-5562-0297-C163-13189216F302}"/>
              </a:ext>
            </a:extLst>
          </p:cNvPr>
          <p:cNvSpPr/>
          <p:nvPr/>
        </p:nvSpPr>
        <p:spPr>
          <a:xfrm>
            <a:off x="1926115" y="2024447"/>
            <a:ext cx="3116148" cy="296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BB1E8F5-3A4F-4671-F556-7A51A1764B71}"/>
              </a:ext>
            </a:extLst>
          </p:cNvPr>
          <p:cNvSpPr/>
          <p:nvPr/>
        </p:nvSpPr>
        <p:spPr>
          <a:xfrm>
            <a:off x="1416663" y="3324597"/>
            <a:ext cx="3116148" cy="296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D8F09BD-93A7-2D2F-C367-726A129DE447}"/>
              </a:ext>
            </a:extLst>
          </p:cNvPr>
          <p:cNvSpPr/>
          <p:nvPr/>
        </p:nvSpPr>
        <p:spPr>
          <a:xfrm>
            <a:off x="1486332" y="4637155"/>
            <a:ext cx="3116148" cy="41381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6FDF2E9-15E9-FB5C-0BDF-CEF33F992505}"/>
              </a:ext>
            </a:extLst>
          </p:cNvPr>
          <p:cNvSpPr/>
          <p:nvPr/>
        </p:nvSpPr>
        <p:spPr>
          <a:xfrm>
            <a:off x="1616960" y="5964752"/>
            <a:ext cx="2985520" cy="296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AB43AB7F-10E8-873B-EF19-174DA50A3145}"/>
              </a:ext>
            </a:extLst>
          </p:cNvPr>
          <p:cNvSpPr/>
          <p:nvPr/>
        </p:nvSpPr>
        <p:spPr>
          <a:xfrm>
            <a:off x="6948786" y="1167093"/>
            <a:ext cx="3116148" cy="296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607FE9CD-1F66-00EB-BCFE-26FEBBC046CB}"/>
              </a:ext>
            </a:extLst>
          </p:cNvPr>
          <p:cNvSpPr/>
          <p:nvPr/>
        </p:nvSpPr>
        <p:spPr>
          <a:xfrm>
            <a:off x="7033692" y="3393079"/>
            <a:ext cx="3116148" cy="296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8AF6629F-6D67-05A9-7EF4-5E54A6584FC4}"/>
              </a:ext>
            </a:extLst>
          </p:cNvPr>
          <p:cNvSpPr/>
          <p:nvPr/>
        </p:nvSpPr>
        <p:spPr>
          <a:xfrm>
            <a:off x="6948786" y="4075612"/>
            <a:ext cx="3116148" cy="31029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9C5DE62B-D1A2-A006-7AB3-7A3F80A16403}"/>
              </a:ext>
            </a:extLst>
          </p:cNvPr>
          <p:cNvSpPr/>
          <p:nvPr/>
        </p:nvSpPr>
        <p:spPr>
          <a:xfrm>
            <a:off x="7254240" y="5355477"/>
            <a:ext cx="2895600" cy="29638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550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9</TotalTime>
  <Words>114</Words>
  <Application>Microsoft Office PowerPoint</Application>
  <PresentationFormat>Widescreen</PresentationFormat>
  <Paragraphs>25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Ohio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vat, Francesca</dc:creator>
  <cp:lastModifiedBy>Lovat, Francesca</cp:lastModifiedBy>
  <cp:revision>4</cp:revision>
  <dcterms:created xsi:type="dcterms:W3CDTF">2023-10-23T19:53:32Z</dcterms:created>
  <dcterms:modified xsi:type="dcterms:W3CDTF">2023-10-24T16:42:07Z</dcterms:modified>
</cp:coreProperties>
</file>